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98" r:id="rId2"/>
    <p:sldId id="302" r:id="rId3"/>
    <p:sldId id="299" r:id="rId4"/>
  </p:sldIdLst>
  <p:sldSz cx="9359900" cy="12236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19CFF"/>
    <a:srgbClr val="00BA38"/>
    <a:srgbClr val="F8766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31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bas Shafiee" userId="12820246-2dc0-43d8-972d-009df2e13211" providerId="ADAL" clId="{F309CFF3-C2E1-433B-96EC-C82FBF4CA45A}"/>
    <pc:docChg chg="undo custSel addSld delSld modSld">
      <pc:chgData name="Abbas Shafiee" userId="12820246-2dc0-43d8-972d-009df2e13211" providerId="ADAL" clId="{F309CFF3-C2E1-433B-96EC-C82FBF4CA45A}" dt="2026-05-14T04:09:26.176" v="6" actId="1036"/>
      <pc:docMkLst>
        <pc:docMk/>
      </pc:docMkLst>
      <pc:sldChg chg="modSp mod">
        <pc:chgData name="Abbas Shafiee" userId="12820246-2dc0-43d8-972d-009df2e13211" providerId="ADAL" clId="{F309CFF3-C2E1-433B-96EC-C82FBF4CA45A}" dt="2026-05-14T04:09:26.176" v="6" actId="1036"/>
        <pc:sldMkLst>
          <pc:docMk/>
          <pc:sldMk cId="210514732" sldId="298"/>
        </pc:sldMkLst>
        <pc:spChg chg="mod">
          <ac:chgData name="Abbas Shafiee" userId="12820246-2dc0-43d8-972d-009df2e13211" providerId="ADAL" clId="{F309CFF3-C2E1-433B-96EC-C82FBF4CA45A}" dt="2026-05-14T04:09:26.176" v="6" actId="1036"/>
          <ac:spMkLst>
            <pc:docMk/>
            <pc:sldMk cId="210514732" sldId="298"/>
            <ac:spMk id="14" creationId="{2D5B24B6-542E-4BBA-67FA-CB30332EF02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221B2F-1723-40EF-82A4-4B9A680289F2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7900" y="1143000"/>
            <a:ext cx="2362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7E0FAC-8123-40C2-9377-3FE8633F642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56933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2F9293-A5D4-B549-8613-A057989288C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9237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01993" y="2002587"/>
            <a:ext cx="7955915" cy="4260097"/>
          </a:xfrm>
        </p:spPr>
        <p:txBody>
          <a:bodyPr anchor="b"/>
          <a:lstStyle>
            <a:lvl1pPr algn="ctr">
              <a:defRPr sz="6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9988" y="6426969"/>
            <a:ext cx="7019925" cy="2954309"/>
          </a:xfrm>
        </p:spPr>
        <p:txBody>
          <a:bodyPr/>
          <a:lstStyle>
            <a:lvl1pPr marL="0" indent="0" algn="ctr">
              <a:buNone/>
              <a:defRPr sz="2457"/>
            </a:lvl1pPr>
            <a:lvl2pPr marL="467990" indent="0" algn="ctr">
              <a:buNone/>
              <a:defRPr sz="2047"/>
            </a:lvl2pPr>
            <a:lvl3pPr marL="935980" indent="0" algn="ctr">
              <a:buNone/>
              <a:defRPr sz="1842"/>
            </a:lvl3pPr>
            <a:lvl4pPr marL="1403970" indent="0" algn="ctr">
              <a:buNone/>
              <a:defRPr sz="1638"/>
            </a:lvl4pPr>
            <a:lvl5pPr marL="1871960" indent="0" algn="ctr">
              <a:buNone/>
              <a:defRPr sz="1638"/>
            </a:lvl5pPr>
            <a:lvl6pPr marL="2339950" indent="0" algn="ctr">
              <a:buNone/>
              <a:defRPr sz="1638"/>
            </a:lvl6pPr>
            <a:lvl7pPr marL="2807940" indent="0" algn="ctr">
              <a:buNone/>
              <a:defRPr sz="1638"/>
            </a:lvl7pPr>
            <a:lvl8pPr marL="3275929" indent="0" algn="ctr">
              <a:buNone/>
              <a:defRPr sz="1638"/>
            </a:lvl8pPr>
            <a:lvl9pPr marL="3743919" indent="0" algn="ctr">
              <a:buNone/>
              <a:defRPr sz="163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26280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7177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98179" y="651478"/>
            <a:ext cx="2018228" cy="1036982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3493" y="651478"/>
            <a:ext cx="5937687" cy="1036982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77005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9122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8619" y="3050619"/>
            <a:ext cx="8072914" cy="5090022"/>
          </a:xfrm>
        </p:spPr>
        <p:txBody>
          <a:bodyPr anchor="b"/>
          <a:lstStyle>
            <a:lvl1pPr>
              <a:defRPr sz="6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8619" y="8188794"/>
            <a:ext cx="8072914" cy="2676723"/>
          </a:xfrm>
        </p:spPr>
        <p:txBody>
          <a:bodyPr/>
          <a:lstStyle>
            <a:lvl1pPr marL="0" indent="0">
              <a:buNone/>
              <a:defRPr sz="2457">
                <a:solidFill>
                  <a:schemeClr val="tx1">
                    <a:tint val="82000"/>
                  </a:schemeClr>
                </a:solidFill>
              </a:defRPr>
            </a:lvl1pPr>
            <a:lvl2pPr marL="467990" indent="0">
              <a:buNone/>
              <a:defRPr sz="2047">
                <a:solidFill>
                  <a:schemeClr val="tx1">
                    <a:tint val="82000"/>
                  </a:schemeClr>
                </a:solidFill>
              </a:defRPr>
            </a:lvl2pPr>
            <a:lvl3pPr marL="935980" indent="0">
              <a:buNone/>
              <a:defRPr sz="1842">
                <a:solidFill>
                  <a:schemeClr val="tx1">
                    <a:tint val="82000"/>
                  </a:schemeClr>
                </a:solidFill>
              </a:defRPr>
            </a:lvl3pPr>
            <a:lvl4pPr marL="1403970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4pPr>
            <a:lvl5pPr marL="1871960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5pPr>
            <a:lvl6pPr marL="2339950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6pPr>
            <a:lvl7pPr marL="2807940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7pPr>
            <a:lvl8pPr marL="3275929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8pPr>
            <a:lvl9pPr marL="3743919" indent="0">
              <a:buNone/>
              <a:defRPr sz="163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18659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3493" y="3257388"/>
            <a:ext cx="3977958" cy="77639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8449" y="3257388"/>
            <a:ext cx="3977958" cy="77639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4820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651480"/>
            <a:ext cx="8072914" cy="2365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4713" y="2999630"/>
            <a:ext cx="3959676" cy="1470073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4713" y="4469703"/>
            <a:ext cx="3959676" cy="65742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38450" y="2999630"/>
            <a:ext cx="3979177" cy="1470073"/>
          </a:xfrm>
        </p:spPr>
        <p:txBody>
          <a:bodyPr anchor="b"/>
          <a:lstStyle>
            <a:lvl1pPr marL="0" indent="0">
              <a:buNone/>
              <a:defRPr sz="2457" b="1"/>
            </a:lvl1pPr>
            <a:lvl2pPr marL="467990" indent="0">
              <a:buNone/>
              <a:defRPr sz="2047" b="1"/>
            </a:lvl2pPr>
            <a:lvl3pPr marL="935980" indent="0">
              <a:buNone/>
              <a:defRPr sz="1842" b="1"/>
            </a:lvl3pPr>
            <a:lvl4pPr marL="1403970" indent="0">
              <a:buNone/>
              <a:defRPr sz="1638" b="1"/>
            </a:lvl4pPr>
            <a:lvl5pPr marL="1871960" indent="0">
              <a:buNone/>
              <a:defRPr sz="1638" b="1"/>
            </a:lvl5pPr>
            <a:lvl6pPr marL="2339950" indent="0">
              <a:buNone/>
              <a:defRPr sz="1638" b="1"/>
            </a:lvl6pPr>
            <a:lvl7pPr marL="2807940" indent="0">
              <a:buNone/>
              <a:defRPr sz="1638" b="1"/>
            </a:lvl7pPr>
            <a:lvl8pPr marL="3275929" indent="0">
              <a:buNone/>
              <a:defRPr sz="1638" b="1"/>
            </a:lvl8pPr>
            <a:lvl9pPr marL="3743919" indent="0">
              <a:buNone/>
              <a:defRPr sz="163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38450" y="4469703"/>
            <a:ext cx="3979177" cy="65742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18423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7939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99065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815763"/>
            <a:ext cx="3018811" cy="2855172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79177" y="1761825"/>
            <a:ext cx="4738449" cy="8695811"/>
          </a:xfrm>
        </p:spPr>
        <p:txBody>
          <a:bodyPr/>
          <a:lstStyle>
            <a:lvl1pPr>
              <a:defRPr sz="3276"/>
            </a:lvl1pPr>
            <a:lvl2pPr>
              <a:defRPr sz="2866"/>
            </a:lvl2pPr>
            <a:lvl3pPr>
              <a:defRPr sz="2457"/>
            </a:lvl3pPr>
            <a:lvl4pPr>
              <a:defRPr sz="2047"/>
            </a:lvl4pPr>
            <a:lvl5pPr>
              <a:defRPr sz="2047"/>
            </a:lvl5pPr>
            <a:lvl6pPr>
              <a:defRPr sz="2047"/>
            </a:lvl6pPr>
            <a:lvl7pPr>
              <a:defRPr sz="2047"/>
            </a:lvl7pPr>
            <a:lvl8pPr>
              <a:defRPr sz="2047"/>
            </a:lvl8pPr>
            <a:lvl9pPr>
              <a:defRPr sz="204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3670935"/>
            <a:ext cx="3018811" cy="6800861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21158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4712" y="815763"/>
            <a:ext cx="3018811" cy="2855172"/>
          </a:xfrm>
        </p:spPr>
        <p:txBody>
          <a:bodyPr anchor="b"/>
          <a:lstStyle>
            <a:lvl1pPr>
              <a:defRPr sz="32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79177" y="1761825"/>
            <a:ext cx="4738449" cy="8695811"/>
          </a:xfrm>
        </p:spPr>
        <p:txBody>
          <a:bodyPr anchor="t"/>
          <a:lstStyle>
            <a:lvl1pPr marL="0" indent="0">
              <a:buNone/>
              <a:defRPr sz="3276"/>
            </a:lvl1pPr>
            <a:lvl2pPr marL="467990" indent="0">
              <a:buNone/>
              <a:defRPr sz="2866"/>
            </a:lvl2pPr>
            <a:lvl3pPr marL="935980" indent="0">
              <a:buNone/>
              <a:defRPr sz="2457"/>
            </a:lvl3pPr>
            <a:lvl4pPr marL="1403970" indent="0">
              <a:buNone/>
              <a:defRPr sz="2047"/>
            </a:lvl4pPr>
            <a:lvl5pPr marL="1871960" indent="0">
              <a:buNone/>
              <a:defRPr sz="2047"/>
            </a:lvl5pPr>
            <a:lvl6pPr marL="2339950" indent="0">
              <a:buNone/>
              <a:defRPr sz="2047"/>
            </a:lvl6pPr>
            <a:lvl7pPr marL="2807940" indent="0">
              <a:buNone/>
              <a:defRPr sz="2047"/>
            </a:lvl7pPr>
            <a:lvl8pPr marL="3275929" indent="0">
              <a:buNone/>
              <a:defRPr sz="2047"/>
            </a:lvl8pPr>
            <a:lvl9pPr marL="3743919" indent="0">
              <a:buNone/>
              <a:defRPr sz="204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4712" y="3670935"/>
            <a:ext cx="3018811" cy="6800861"/>
          </a:xfrm>
        </p:spPr>
        <p:txBody>
          <a:bodyPr/>
          <a:lstStyle>
            <a:lvl1pPr marL="0" indent="0">
              <a:buNone/>
              <a:defRPr sz="1638"/>
            </a:lvl1pPr>
            <a:lvl2pPr marL="467990" indent="0">
              <a:buNone/>
              <a:defRPr sz="1433"/>
            </a:lvl2pPr>
            <a:lvl3pPr marL="935980" indent="0">
              <a:buNone/>
              <a:defRPr sz="1228"/>
            </a:lvl3pPr>
            <a:lvl4pPr marL="1403970" indent="0">
              <a:buNone/>
              <a:defRPr sz="1024"/>
            </a:lvl4pPr>
            <a:lvl5pPr marL="1871960" indent="0">
              <a:buNone/>
              <a:defRPr sz="1024"/>
            </a:lvl5pPr>
            <a:lvl6pPr marL="2339950" indent="0">
              <a:buNone/>
              <a:defRPr sz="1024"/>
            </a:lvl6pPr>
            <a:lvl7pPr marL="2807940" indent="0">
              <a:buNone/>
              <a:defRPr sz="1024"/>
            </a:lvl7pPr>
            <a:lvl8pPr marL="3275929" indent="0">
              <a:buNone/>
              <a:defRPr sz="1024"/>
            </a:lvl8pPr>
            <a:lvl9pPr marL="3743919" indent="0">
              <a:buNone/>
              <a:defRPr sz="102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8612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3493" y="651480"/>
            <a:ext cx="8072914" cy="2365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3493" y="3257388"/>
            <a:ext cx="8072914" cy="77639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3493" y="11341379"/>
            <a:ext cx="2105978" cy="6514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2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7C43DAA-68E3-4DF7-A026-6FB6BDB6D81C}" type="datetimeFigureOut">
              <a:rPr lang="en-AU" smtClean="0"/>
              <a:t>14/05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00467" y="11341379"/>
            <a:ext cx="3158966" cy="6514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2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610429" y="11341379"/>
            <a:ext cx="2105978" cy="6514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2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2E0499-625C-4D43-B592-39EA0B10069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2844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35980" rtl="0" eaLnBrk="1" latinLnBrk="0" hangingPunct="1">
        <a:lnSpc>
          <a:spcPct val="90000"/>
        </a:lnSpc>
        <a:spcBef>
          <a:spcPct val="0"/>
        </a:spcBef>
        <a:buNone/>
        <a:defRPr sz="450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3995" indent="-233995" algn="l" defTabSz="935980" rtl="0" eaLnBrk="1" latinLnBrk="0" hangingPunct="1">
        <a:lnSpc>
          <a:spcPct val="90000"/>
        </a:lnSpc>
        <a:spcBef>
          <a:spcPts val="1024"/>
        </a:spcBef>
        <a:buFont typeface="Arial" panose="020B0604020202020204" pitchFamily="34" charset="0"/>
        <a:buChar char="•"/>
        <a:defRPr sz="2866" kern="1200">
          <a:solidFill>
            <a:schemeClr val="tx1"/>
          </a:solidFill>
          <a:latin typeface="+mn-lt"/>
          <a:ea typeface="+mn-ea"/>
          <a:cs typeface="+mn-cs"/>
        </a:defRPr>
      </a:lvl1pPr>
      <a:lvl2pPr marL="70198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2457" kern="1200">
          <a:solidFill>
            <a:schemeClr val="tx1"/>
          </a:solidFill>
          <a:latin typeface="+mn-lt"/>
          <a:ea typeface="+mn-ea"/>
          <a:cs typeface="+mn-cs"/>
        </a:defRPr>
      </a:lvl2pPr>
      <a:lvl3pPr marL="116997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2047" kern="1200">
          <a:solidFill>
            <a:schemeClr val="tx1"/>
          </a:solidFill>
          <a:latin typeface="+mn-lt"/>
          <a:ea typeface="+mn-ea"/>
          <a:cs typeface="+mn-cs"/>
        </a:defRPr>
      </a:lvl3pPr>
      <a:lvl4pPr marL="163796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210595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573945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304193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50992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977914" indent="-233995" algn="l" defTabSz="935980" rtl="0" eaLnBrk="1" latinLnBrk="0" hangingPunct="1">
        <a:lnSpc>
          <a:spcPct val="90000"/>
        </a:lnSpc>
        <a:spcBef>
          <a:spcPts val="512"/>
        </a:spcBef>
        <a:buFont typeface="Arial" panose="020B0604020202020204" pitchFamily="34" charset="0"/>
        <a:buChar char="•"/>
        <a:defRPr sz="18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1pPr>
      <a:lvl2pPr marL="46799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93598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3pPr>
      <a:lvl4pPr marL="140397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4pPr>
      <a:lvl5pPr marL="187196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5pPr>
      <a:lvl6pPr marL="233995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6pPr>
      <a:lvl7pPr marL="2807940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7pPr>
      <a:lvl8pPr marL="3275929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8pPr>
      <a:lvl9pPr marL="3743919" algn="l" defTabSz="935980" rtl="0" eaLnBrk="1" latinLnBrk="0" hangingPunct="1">
        <a:defRPr sz="18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4.png"/><Relationship Id="rId7" Type="http://schemas.openxmlformats.org/officeDocument/2006/relationships/image" Target="../media/image27.png"/><Relationship Id="rId12" Type="http://schemas.openxmlformats.org/officeDocument/2006/relationships/image" Target="../media/image3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2D5B24B6-542E-4BBA-67FA-CB30332EF026}"/>
              </a:ext>
            </a:extLst>
          </p:cNvPr>
          <p:cNvSpPr txBox="1"/>
          <p:nvPr/>
        </p:nvSpPr>
        <p:spPr>
          <a:xfrm>
            <a:off x="15558" y="10230308"/>
            <a:ext cx="943483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single cell RNA-sequencing analyses of murine aortic endothelial compartment.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ing across 3 aortic samples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gleR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biased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eling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d)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s of top DE genes in EVP (C) and M (D) clusters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f)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ING pathway analysis plots of top DE genes in EVP (E) and M (F) clusters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</a:t>
            </a:r>
            <a:r>
              <a:rPr lang="en-AU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olin plots showing expression of endothelial markers Chh5, Pecam1 and CD34 in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usters of endothelial (Lin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4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ells from murine aorta (n=3). j) Violin plots showing individual expression of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D34, (ii) PROCR and (iii) PDGFRA in murine aorta (n=3)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9C8C2A74-AF40-47B0-5C47-3A7FC0F3C08C}"/>
              </a:ext>
            </a:extLst>
          </p:cNvPr>
          <p:cNvGrpSpPr/>
          <p:nvPr/>
        </p:nvGrpSpPr>
        <p:grpSpPr>
          <a:xfrm>
            <a:off x="-40594" y="-47034"/>
            <a:ext cx="9384936" cy="10354815"/>
            <a:chOff x="-40594" y="-47033"/>
            <a:chExt cx="9400494" cy="10237544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F18B1C1-33AB-BCD0-84A7-5F01A3FEF325}"/>
                </a:ext>
              </a:extLst>
            </p:cNvPr>
            <p:cNvSpPr txBox="1"/>
            <p:nvPr/>
          </p:nvSpPr>
          <p:spPr>
            <a:xfrm>
              <a:off x="3023420" y="-47033"/>
              <a:ext cx="407257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FC50151-4D34-A0F4-D10A-37CA0086EA28}"/>
                </a:ext>
              </a:extLst>
            </p:cNvPr>
            <p:cNvSpPr txBox="1"/>
            <p:nvPr/>
          </p:nvSpPr>
          <p:spPr>
            <a:xfrm>
              <a:off x="-13266" y="2545091"/>
              <a:ext cx="462191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)</a:t>
              </a:r>
            </a:p>
          </p:txBody>
        </p:sp>
        <p:pic>
          <p:nvPicPr>
            <p:cNvPr id="11" name="Picture 10" descr="Chart, scatter chart&#10;&#10;Description automatically generated">
              <a:extLst>
                <a:ext uri="{FF2B5EF4-FFF2-40B4-BE49-F238E27FC236}">
                  <a16:creationId xmlns:a16="http://schemas.microsoft.com/office/drawing/2014/main" id="{21EB074D-FC13-C8BA-77D4-F2BCF1AACF1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9818" y="2992584"/>
              <a:ext cx="3077230" cy="2536528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DD961BE-8B7C-5B75-0C7E-D667D2626FC6}"/>
                </a:ext>
              </a:extLst>
            </p:cNvPr>
            <p:cNvSpPr txBox="1"/>
            <p:nvPr/>
          </p:nvSpPr>
          <p:spPr>
            <a:xfrm>
              <a:off x="1110761" y="2586937"/>
              <a:ext cx="1615309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 DE Genes</a:t>
              </a:r>
            </a:p>
          </p:txBody>
        </p:sp>
        <p:pic>
          <p:nvPicPr>
            <p:cNvPr id="22" name="Picture 21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07F30675-FFB9-355E-F212-EDDC0E69A9E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27048" y="2622833"/>
              <a:ext cx="3340958" cy="3081637"/>
            </a:xfrm>
            <a:prstGeom prst="rect">
              <a:avLst/>
            </a:prstGeom>
          </p:spPr>
        </p:pic>
        <p:pic>
          <p:nvPicPr>
            <p:cNvPr id="23" name="Picture 22" descr="A picture containing web, outdoor object&#10;&#10;Description automatically generated">
              <a:extLst>
                <a:ext uri="{FF2B5EF4-FFF2-40B4-BE49-F238E27FC236}">
                  <a16:creationId xmlns:a16="http://schemas.microsoft.com/office/drawing/2014/main" id="{ED4AC14C-042C-F161-6480-192D31B77F8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22657" y="2341306"/>
              <a:ext cx="3023471" cy="3185522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858F561-D954-D2BC-70FF-5E6ECCD458E3}"/>
                </a:ext>
              </a:extLst>
            </p:cNvPr>
            <p:cNvSpPr txBox="1"/>
            <p:nvPr/>
          </p:nvSpPr>
          <p:spPr>
            <a:xfrm>
              <a:off x="3199068" y="2545091"/>
              <a:ext cx="582416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1A391C7-359D-7E7C-1D4E-F717315671BE}"/>
                </a:ext>
              </a:extLst>
            </p:cNvPr>
            <p:cNvSpPr txBox="1"/>
            <p:nvPr/>
          </p:nvSpPr>
          <p:spPr>
            <a:xfrm>
              <a:off x="6323795" y="2618686"/>
              <a:ext cx="462191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)</a:t>
              </a: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2280E479-597F-1CB6-C9A4-A4D95FB6DC8F}"/>
                </a:ext>
              </a:extLst>
            </p:cNvPr>
            <p:cNvGrpSpPr/>
            <p:nvPr/>
          </p:nvGrpSpPr>
          <p:grpSpPr>
            <a:xfrm>
              <a:off x="-40594" y="-42148"/>
              <a:ext cx="3023420" cy="2382039"/>
              <a:chOff x="63430" y="-9151"/>
              <a:chExt cx="3023420" cy="2382039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E8A5EF18-6DE1-A6F7-2BBC-00585C1F82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9540" t="8309" b="15411"/>
              <a:stretch/>
            </p:blipFill>
            <p:spPr>
              <a:xfrm>
                <a:off x="120695" y="97706"/>
                <a:ext cx="2739209" cy="2275182"/>
              </a:xfrm>
              <a:prstGeom prst="rect">
                <a:avLst/>
              </a:prstGeom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ACB25753-33DD-EC48-F595-7DA7167AEFC6}"/>
                  </a:ext>
                </a:extLst>
              </p:cNvPr>
              <p:cNvSpPr txBox="1"/>
              <p:nvPr/>
            </p:nvSpPr>
            <p:spPr>
              <a:xfrm>
                <a:off x="63430" y="-9151"/>
                <a:ext cx="407257" cy="3042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)</a:t>
                </a:r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7A1AFB92-90C1-3F7C-DD4E-3D6986002853}"/>
                  </a:ext>
                </a:extLst>
              </p:cNvPr>
              <p:cNvSpPr txBox="1"/>
              <p:nvPr/>
            </p:nvSpPr>
            <p:spPr>
              <a:xfrm>
                <a:off x="2476083" y="888759"/>
                <a:ext cx="610767" cy="73866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on4</a:t>
                </a:r>
              </a:p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on6</a:t>
                </a:r>
              </a:p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on9</a:t>
                </a:r>
                <a:endParaRPr lang="en-AU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" name="Oval 2">
                <a:extLst>
                  <a:ext uri="{FF2B5EF4-FFF2-40B4-BE49-F238E27FC236}">
                    <a16:creationId xmlns:a16="http://schemas.microsoft.com/office/drawing/2014/main" id="{1C729CD6-CE27-DC98-D4D8-3B94BC62E342}"/>
                  </a:ext>
                </a:extLst>
              </p:cNvPr>
              <p:cNvSpPr/>
              <p:nvPr/>
            </p:nvSpPr>
            <p:spPr>
              <a:xfrm>
                <a:off x="2412894" y="986382"/>
                <a:ext cx="104400" cy="104775"/>
              </a:xfrm>
              <a:prstGeom prst="ellipse">
                <a:avLst/>
              </a:prstGeom>
              <a:solidFill>
                <a:srgbClr val="F8766D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Oval 14">
                <a:extLst>
                  <a:ext uri="{FF2B5EF4-FFF2-40B4-BE49-F238E27FC236}">
                    <a16:creationId xmlns:a16="http://schemas.microsoft.com/office/drawing/2014/main" id="{0E7919F7-5D3A-3A91-C2E2-B00A57834B7C}"/>
                  </a:ext>
                </a:extLst>
              </p:cNvPr>
              <p:cNvSpPr/>
              <p:nvPr/>
            </p:nvSpPr>
            <p:spPr>
              <a:xfrm>
                <a:off x="2412894" y="1204310"/>
                <a:ext cx="104400" cy="104775"/>
              </a:xfrm>
              <a:prstGeom prst="ellipse">
                <a:avLst/>
              </a:prstGeom>
              <a:solidFill>
                <a:srgbClr val="00BA38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Oval 15">
                <a:extLst>
                  <a:ext uri="{FF2B5EF4-FFF2-40B4-BE49-F238E27FC236}">
                    <a16:creationId xmlns:a16="http://schemas.microsoft.com/office/drawing/2014/main" id="{37C21F78-6EE0-ED7E-CE5E-0A69B7EC79CF}"/>
                  </a:ext>
                </a:extLst>
              </p:cNvPr>
              <p:cNvSpPr/>
              <p:nvPr/>
            </p:nvSpPr>
            <p:spPr>
              <a:xfrm>
                <a:off x="2412894" y="1401687"/>
                <a:ext cx="104400" cy="104775"/>
              </a:xfrm>
              <a:prstGeom prst="ellipse">
                <a:avLst/>
              </a:prstGeom>
              <a:solidFill>
                <a:srgbClr val="619CFF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66EBEDB-73EE-2255-9A82-CF8FEBE4DBD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893654" y="30019"/>
              <a:ext cx="3492485" cy="2612896"/>
            </a:xfrm>
            <a:prstGeom prst="rect">
              <a:avLst/>
            </a:prstGeom>
          </p:spPr>
        </p:pic>
        <p:pic>
          <p:nvPicPr>
            <p:cNvPr id="10" name="Picture 9" descr="Chart, scatter chart&#10;&#10;Description automatically generated">
              <a:extLst>
                <a:ext uri="{FF2B5EF4-FFF2-40B4-BE49-F238E27FC236}">
                  <a16:creationId xmlns:a16="http://schemas.microsoft.com/office/drawing/2014/main" id="{98B48487-2C08-F4B1-F5B8-A871559C7BD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82672" y="120075"/>
              <a:ext cx="3077228" cy="2536527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39BD411-D8C4-5212-5E78-B366CC641D7F}"/>
                </a:ext>
              </a:extLst>
            </p:cNvPr>
            <p:cNvSpPr txBox="1"/>
            <p:nvPr/>
          </p:nvSpPr>
          <p:spPr>
            <a:xfrm>
              <a:off x="5990529" y="-21952"/>
              <a:ext cx="582416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36FD032-C729-10E6-BC19-DAE2AB5789C6}"/>
                </a:ext>
              </a:extLst>
            </p:cNvPr>
            <p:cNvSpPr txBox="1"/>
            <p:nvPr/>
          </p:nvSpPr>
          <p:spPr>
            <a:xfrm>
              <a:off x="6965256" y="-9448"/>
              <a:ext cx="1813287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VP DE Genes</a:t>
              </a:r>
            </a:p>
          </p:txBody>
        </p:sp>
        <p:pic>
          <p:nvPicPr>
            <p:cNvPr id="18" name="Picture 17" descr="A graph of a number of objects&#10;&#10;Description automatically generated with medium confidence">
              <a:extLst>
                <a:ext uri="{FF2B5EF4-FFF2-40B4-BE49-F238E27FC236}">
                  <a16:creationId xmlns:a16="http://schemas.microsoft.com/office/drawing/2014/main" id="{0A81AE75-4242-6A72-A126-46180BE7EA4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5106" y="5667062"/>
              <a:ext cx="3835400" cy="2209800"/>
            </a:xfrm>
            <a:prstGeom prst="rect">
              <a:avLst/>
            </a:prstGeom>
          </p:spPr>
        </p:pic>
        <p:pic>
          <p:nvPicPr>
            <p:cNvPr id="19" name="Picture 18" descr="A graph of a graph showing a number of objects&#10;&#10;Description automatically generated with medium confidence">
              <a:extLst>
                <a:ext uri="{FF2B5EF4-FFF2-40B4-BE49-F238E27FC236}">
                  <a16:creationId xmlns:a16="http://schemas.microsoft.com/office/drawing/2014/main" id="{656320F1-4AC8-8C56-9FFA-F362B41577A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880506" y="5686427"/>
              <a:ext cx="3835400" cy="2209800"/>
            </a:xfrm>
            <a:prstGeom prst="rect">
              <a:avLst/>
            </a:prstGeom>
          </p:spPr>
        </p:pic>
        <p:pic>
          <p:nvPicPr>
            <p:cNvPr id="20" name="Picture 19" descr="A graph of data with different colored lines&#10;&#10;Description automatically generated with medium confidence">
              <a:extLst>
                <a:ext uri="{FF2B5EF4-FFF2-40B4-BE49-F238E27FC236}">
                  <a16:creationId xmlns:a16="http://schemas.microsoft.com/office/drawing/2014/main" id="{3757EAD9-0501-B773-D620-219FF3D4424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5106" y="7980711"/>
              <a:ext cx="3835400" cy="22098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96C73DD-7FBD-29F6-54A8-F005AE115DF3}"/>
                </a:ext>
              </a:extLst>
            </p:cNvPr>
            <p:cNvSpPr txBox="1"/>
            <p:nvPr/>
          </p:nvSpPr>
          <p:spPr>
            <a:xfrm>
              <a:off x="51670" y="5609536"/>
              <a:ext cx="736349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E96FDA0-CCF7-4397-4A34-BB1BC5CD5514}"/>
                </a:ext>
              </a:extLst>
            </p:cNvPr>
            <p:cNvSpPr txBox="1"/>
            <p:nvPr/>
          </p:nvSpPr>
          <p:spPr>
            <a:xfrm>
              <a:off x="3880506" y="5609536"/>
              <a:ext cx="736349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)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79743D9-6B8D-F1E0-7483-BA88BE4A174E}"/>
                </a:ext>
              </a:extLst>
            </p:cNvPr>
            <p:cNvSpPr txBox="1"/>
            <p:nvPr/>
          </p:nvSpPr>
          <p:spPr>
            <a:xfrm>
              <a:off x="75748" y="7858047"/>
              <a:ext cx="736349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78DA362C-7161-D9D2-A0E2-0FD0787135F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rcRect r="16783"/>
            <a:stretch/>
          </p:blipFill>
          <p:spPr>
            <a:xfrm>
              <a:off x="3890259" y="8326813"/>
              <a:ext cx="1676422" cy="1459127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F53D6E15-6D1A-6DA8-B07A-6FAA6FA9752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rcRect r="16783"/>
            <a:stretch/>
          </p:blipFill>
          <p:spPr>
            <a:xfrm>
              <a:off x="5612515" y="8326812"/>
              <a:ext cx="1676423" cy="1459127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6C768A91-4EB5-BB36-9AE7-8EFB7DC9BDC2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345363" y="8326811"/>
              <a:ext cx="2014537" cy="1459127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E934695-64C8-E432-B0A3-0C8E64FBEC9C}"/>
                </a:ext>
              </a:extLst>
            </p:cNvPr>
            <p:cNvSpPr txBox="1"/>
            <p:nvPr/>
          </p:nvSpPr>
          <p:spPr>
            <a:xfrm>
              <a:off x="3874686" y="7885763"/>
              <a:ext cx="736349" cy="304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j)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A398401A-44FC-C90B-A010-3B5CF42C2453}"/>
              </a:ext>
            </a:extLst>
          </p:cNvPr>
          <p:cNvSpPr txBox="1"/>
          <p:nvPr/>
        </p:nvSpPr>
        <p:spPr>
          <a:xfrm>
            <a:off x="2938138" y="-6126"/>
            <a:ext cx="407257" cy="366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780" b="1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210514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5372827-E169-3795-8B43-609CE33D0602}"/>
              </a:ext>
            </a:extLst>
          </p:cNvPr>
          <p:cNvGrpSpPr/>
          <p:nvPr/>
        </p:nvGrpSpPr>
        <p:grpSpPr>
          <a:xfrm>
            <a:off x="16559" y="-23036"/>
            <a:ext cx="9053930" cy="10355182"/>
            <a:chOff x="16559" y="-23036"/>
            <a:chExt cx="9053930" cy="10355182"/>
          </a:xfrm>
        </p:grpSpPr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96713671-8F29-8C05-B2D4-6A5E295141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566" r="48262" b="12851"/>
            <a:stretch/>
          </p:blipFill>
          <p:spPr>
            <a:xfrm>
              <a:off x="244738" y="3081476"/>
              <a:ext cx="2174762" cy="2048727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ACC8661-F2DA-BC87-87E0-2D40B124A0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9631" b="5470"/>
            <a:stretch/>
          </p:blipFill>
          <p:spPr>
            <a:xfrm>
              <a:off x="4753710" y="381365"/>
              <a:ext cx="2145155" cy="208363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B8406B4-C35D-E591-3FAA-9EE786755C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0486" b="5580"/>
            <a:stretch/>
          </p:blipFill>
          <p:spPr>
            <a:xfrm>
              <a:off x="310693" y="321323"/>
              <a:ext cx="2193525" cy="214368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D2B0A328-4813-FAE6-2267-C902E648A6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1141" b="5471"/>
            <a:stretch/>
          </p:blipFill>
          <p:spPr>
            <a:xfrm>
              <a:off x="2587861" y="381365"/>
              <a:ext cx="2099700" cy="2083635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DC8A03D0-0F93-6C0C-2C99-ABB35CFA77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4887" r="49416" b="10274"/>
            <a:stretch/>
          </p:blipFill>
          <p:spPr>
            <a:xfrm>
              <a:off x="4783677" y="3184190"/>
              <a:ext cx="2074045" cy="1946013"/>
            </a:xfrm>
            <a:prstGeom prst="rect">
              <a:avLst/>
            </a:prstGeom>
          </p:spPr>
        </p:pic>
        <p:pic>
          <p:nvPicPr>
            <p:cNvPr id="36" name="Picture 35" descr="Chart, scatter chart&#10;&#10;Description automatically generated">
              <a:extLst>
                <a:ext uri="{FF2B5EF4-FFF2-40B4-BE49-F238E27FC236}">
                  <a16:creationId xmlns:a16="http://schemas.microsoft.com/office/drawing/2014/main" id="{AF70DC65-7171-4292-E132-7C17B24FA1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18" b="6812"/>
            <a:stretch/>
          </p:blipFill>
          <p:spPr>
            <a:xfrm>
              <a:off x="6911562" y="381365"/>
              <a:ext cx="2145155" cy="2143682"/>
            </a:xfrm>
            <a:prstGeom prst="rect">
              <a:avLst/>
            </a:prstGeom>
          </p:spPr>
        </p:pic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3A93EEF8-2484-8A2C-ACD5-B64AE00FD74A}"/>
                </a:ext>
              </a:extLst>
            </p:cNvPr>
            <p:cNvGrpSpPr/>
            <p:nvPr/>
          </p:nvGrpSpPr>
          <p:grpSpPr>
            <a:xfrm>
              <a:off x="320918" y="345113"/>
              <a:ext cx="8663213" cy="2156139"/>
              <a:chOff x="2259871" y="4623515"/>
              <a:chExt cx="4717836" cy="837319"/>
            </a:xfrm>
          </p:grpSpPr>
          <p:cxnSp>
            <p:nvCxnSpPr>
              <p:cNvPr id="49" name="Straight Arrow Connector 48">
                <a:extLst>
                  <a:ext uri="{FF2B5EF4-FFF2-40B4-BE49-F238E27FC236}">
                    <a16:creationId xmlns:a16="http://schemas.microsoft.com/office/drawing/2014/main" id="{6F47EE20-A949-1A0C-2993-F12DB5218C2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259871" y="4623515"/>
                <a:ext cx="10218" cy="83248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>
                <a:extLst>
                  <a:ext uri="{FF2B5EF4-FFF2-40B4-BE49-F238E27FC236}">
                    <a16:creationId xmlns:a16="http://schemas.microsoft.com/office/drawing/2014/main" id="{CF83BBDA-7E39-AB3D-6072-DB5E7B1D96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70089" y="5460834"/>
                <a:ext cx="470761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1E92C410-E8C8-ADA2-2D36-1507677A7EB8}"/>
                </a:ext>
              </a:extLst>
            </p:cNvPr>
            <p:cNvSpPr txBox="1"/>
            <p:nvPr/>
          </p:nvSpPr>
          <p:spPr>
            <a:xfrm>
              <a:off x="1016792" y="2513710"/>
              <a:ext cx="8809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PROCR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C30ED42-DDC4-7C53-F8FD-255CD1EB722F}"/>
                </a:ext>
              </a:extLst>
            </p:cNvPr>
            <p:cNvSpPr txBox="1"/>
            <p:nvPr/>
          </p:nvSpPr>
          <p:spPr>
            <a:xfrm rot="16200000">
              <a:off x="-267761" y="1135594"/>
              <a:ext cx="8764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F9A94B87-D00D-787A-80CA-239CED0A6520}"/>
                </a:ext>
              </a:extLst>
            </p:cNvPr>
            <p:cNvSpPr txBox="1"/>
            <p:nvPr/>
          </p:nvSpPr>
          <p:spPr>
            <a:xfrm>
              <a:off x="3247047" y="2513710"/>
              <a:ext cx="9687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PDGFRA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F2D1AFE-8334-CC0A-43CF-D32BD896B93A}"/>
                </a:ext>
              </a:extLst>
            </p:cNvPr>
            <p:cNvSpPr txBox="1"/>
            <p:nvPr/>
          </p:nvSpPr>
          <p:spPr>
            <a:xfrm>
              <a:off x="5566176" y="2513710"/>
              <a:ext cx="8456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157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352ABF22-1142-1D90-4D93-E143B89E139F}"/>
                </a:ext>
              </a:extLst>
            </p:cNvPr>
            <p:cNvSpPr txBox="1"/>
            <p:nvPr/>
          </p:nvSpPr>
          <p:spPr>
            <a:xfrm>
              <a:off x="7176606" y="2525048"/>
              <a:ext cx="18253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Abcg2/Sox18-YFP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D2DC169-88B2-5228-F592-4372B8464199}"/>
                </a:ext>
              </a:extLst>
            </p:cNvPr>
            <p:cNvSpPr txBox="1"/>
            <p:nvPr/>
          </p:nvSpPr>
          <p:spPr>
            <a:xfrm>
              <a:off x="50706" y="-23036"/>
              <a:ext cx="4056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89580F10-5220-2AF9-857C-1E28CD0390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5437" b="8390"/>
            <a:stretch/>
          </p:blipFill>
          <p:spPr>
            <a:xfrm>
              <a:off x="2587860" y="3057679"/>
              <a:ext cx="2074045" cy="2174100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A90FDD4-AC8B-968A-D833-43FE1DF0EA5E}"/>
                </a:ext>
              </a:extLst>
            </p:cNvPr>
            <p:cNvSpPr txBox="1"/>
            <p:nvPr/>
          </p:nvSpPr>
          <p:spPr>
            <a:xfrm rot="16200000">
              <a:off x="2027205" y="3843066"/>
              <a:ext cx="10112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PROCR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2B2344B-AC75-3448-FA40-C25597D67924}"/>
                </a:ext>
              </a:extLst>
            </p:cNvPr>
            <p:cNvSpPr txBox="1"/>
            <p:nvPr/>
          </p:nvSpPr>
          <p:spPr>
            <a:xfrm>
              <a:off x="1022892" y="5123179"/>
              <a:ext cx="10990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PDGFRA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109F025-6ACE-13DF-1307-8217EC614168}"/>
                </a:ext>
              </a:extLst>
            </p:cNvPr>
            <p:cNvSpPr txBox="1"/>
            <p:nvPr/>
          </p:nvSpPr>
          <p:spPr>
            <a:xfrm>
              <a:off x="3293770" y="5123179"/>
              <a:ext cx="11441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PDGFRA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3D53DCE-863B-A503-48A6-56CADE2F0314}"/>
                </a:ext>
              </a:extLst>
            </p:cNvPr>
            <p:cNvSpPr txBox="1"/>
            <p:nvPr/>
          </p:nvSpPr>
          <p:spPr>
            <a:xfrm rot="16200000">
              <a:off x="4311497" y="3820877"/>
              <a:ext cx="8914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6C1BFF05-54B7-60BB-8CBB-D39758EB1E56}"/>
                </a:ext>
              </a:extLst>
            </p:cNvPr>
            <p:cNvSpPr txBox="1"/>
            <p:nvPr/>
          </p:nvSpPr>
          <p:spPr>
            <a:xfrm>
              <a:off x="5633299" y="5123179"/>
              <a:ext cx="965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CA189226-1DEA-EEB3-AAE8-95CEFFD1F324}"/>
                </a:ext>
              </a:extLst>
            </p:cNvPr>
            <p:cNvSpPr txBox="1"/>
            <p:nvPr/>
          </p:nvSpPr>
          <p:spPr>
            <a:xfrm rot="16200000">
              <a:off x="6477068" y="3812626"/>
              <a:ext cx="9503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78118118-70BF-CBB4-E9BB-AB08EF1DDADB}"/>
                </a:ext>
              </a:extLst>
            </p:cNvPr>
            <p:cNvSpPr txBox="1"/>
            <p:nvPr/>
          </p:nvSpPr>
          <p:spPr>
            <a:xfrm>
              <a:off x="7882566" y="5123179"/>
              <a:ext cx="8950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</a:p>
          </p:txBody>
        </p:sp>
        <p:pic>
          <p:nvPicPr>
            <p:cNvPr id="77" name="Picture 76" descr="Chart, scatter chart&#10;&#10;Description automatically generated">
              <a:extLst>
                <a:ext uri="{FF2B5EF4-FFF2-40B4-BE49-F238E27FC236}">
                  <a16:creationId xmlns:a16="http://schemas.microsoft.com/office/drawing/2014/main" id="{489BF546-82B5-5836-9188-DE0C61C3B7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06" r="2223" b="6921"/>
            <a:stretch/>
          </p:blipFill>
          <p:spPr>
            <a:xfrm>
              <a:off x="7032268" y="3159593"/>
              <a:ext cx="2037734" cy="2031167"/>
            </a:xfrm>
            <a:prstGeom prst="rect">
              <a:avLst/>
            </a:prstGeom>
          </p:spPr>
        </p:pic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417FD673-B201-DC6C-39E1-E69370C485CC}"/>
                </a:ext>
              </a:extLst>
            </p:cNvPr>
            <p:cNvSpPr txBox="1"/>
            <p:nvPr/>
          </p:nvSpPr>
          <p:spPr>
            <a:xfrm>
              <a:off x="107856" y="2886388"/>
              <a:ext cx="4056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FFC61D9D-0B31-D252-E7E7-275A9BA819E0}"/>
                </a:ext>
              </a:extLst>
            </p:cNvPr>
            <p:cNvSpPr txBox="1"/>
            <p:nvPr/>
          </p:nvSpPr>
          <p:spPr>
            <a:xfrm rot="16200000">
              <a:off x="-215397" y="3913790"/>
              <a:ext cx="8764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PROCR</a:t>
              </a:r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ED7EDB2B-343F-BAF1-177C-EAF9F8E29D61}"/>
                </a:ext>
              </a:extLst>
            </p:cNvPr>
            <p:cNvSpPr/>
            <p:nvPr/>
          </p:nvSpPr>
          <p:spPr>
            <a:xfrm>
              <a:off x="1518813" y="415928"/>
              <a:ext cx="900686" cy="176634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0B7DD58B-BE4E-6F5D-5910-D41913E20004}"/>
                </a:ext>
              </a:extLst>
            </p:cNvPr>
            <p:cNvSpPr/>
            <p:nvPr/>
          </p:nvSpPr>
          <p:spPr>
            <a:xfrm>
              <a:off x="3793769" y="469155"/>
              <a:ext cx="817973" cy="177724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9C554B1D-77FC-C967-9BB0-7D19693469B0}"/>
                </a:ext>
              </a:extLst>
            </p:cNvPr>
            <p:cNvSpPr/>
            <p:nvPr/>
          </p:nvSpPr>
          <p:spPr>
            <a:xfrm>
              <a:off x="5983941" y="451346"/>
              <a:ext cx="838478" cy="174982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Freeform: Shape 48">
              <a:extLst>
                <a:ext uri="{FF2B5EF4-FFF2-40B4-BE49-F238E27FC236}">
                  <a16:creationId xmlns:a16="http://schemas.microsoft.com/office/drawing/2014/main" id="{4C4B6629-DE78-C4ED-8590-AEEC7084D69D}"/>
                </a:ext>
              </a:extLst>
            </p:cNvPr>
            <p:cNvSpPr/>
            <p:nvPr/>
          </p:nvSpPr>
          <p:spPr>
            <a:xfrm>
              <a:off x="7900375" y="482321"/>
              <a:ext cx="1101564" cy="1771829"/>
            </a:xfrm>
            <a:custGeom>
              <a:avLst/>
              <a:gdLst>
                <a:gd name="connsiteX0" fmla="*/ 0 w 1088572"/>
                <a:gd name="connsiteY0" fmla="*/ 1719943 h 1719943"/>
                <a:gd name="connsiteX1" fmla="*/ 304800 w 1088572"/>
                <a:gd name="connsiteY1" fmla="*/ 892629 h 1719943"/>
                <a:gd name="connsiteX2" fmla="*/ 402772 w 1088572"/>
                <a:gd name="connsiteY2" fmla="*/ 0 h 1719943"/>
                <a:gd name="connsiteX3" fmla="*/ 1088572 w 1088572"/>
                <a:gd name="connsiteY3" fmla="*/ 10886 h 1719943"/>
                <a:gd name="connsiteX4" fmla="*/ 1088572 w 1088572"/>
                <a:gd name="connsiteY4" fmla="*/ 1719943 h 1719943"/>
                <a:gd name="connsiteX5" fmla="*/ 0 w 1088572"/>
                <a:gd name="connsiteY5" fmla="*/ 1719943 h 171994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088572" h="1719943">
                  <a:moveTo>
                    <a:pt x="0" y="1719943"/>
                  </a:moveTo>
                  <a:lnTo>
                    <a:pt x="304800" y="892629"/>
                  </a:lnTo>
                  <a:lnTo>
                    <a:pt x="402772" y="0"/>
                  </a:lnTo>
                  <a:lnTo>
                    <a:pt x="1088572" y="10886"/>
                  </a:lnTo>
                  <a:lnTo>
                    <a:pt x="1088572" y="1719943"/>
                  </a:lnTo>
                  <a:lnTo>
                    <a:pt x="0" y="1719943"/>
                  </a:lnTo>
                  <a:close/>
                </a:path>
              </a:pathLst>
            </a:cu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198DE031-0C4C-F19F-6322-34AC4D524701}"/>
                </a:ext>
              </a:extLst>
            </p:cNvPr>
            <p:cNvSpPr/>
            <p:nvPr/>
          </p:nvSpPr>
          <p:spPr>
            <a:xfrm>
              <a:off x="1282531" y="3227904"/>
              <a:ext cx="973474" cy="80009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B16038BB-A66A-9FF7-78CD-44B08C87A0CA}"/>
                </a:ext>
              </a:extLst>
            </p:cNvPr>
            <p:cNvSpPr/>
            <p:nvPr/>
          </p:nvSpPr>
          <p:spPr>
            <a:xfrm>
              <a:off x="3630053" y="3253209"/>
              <a:ext cx="973474" cy="80009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BF6668C4-37BA-9F92-900A-3AA9C83A6B42}"/>
                </a:ext>
              </a:extLst>
            </p:cNvPr>
            <p:cNvSpPr/>
            <p:nvPr/>
          </p:nvSpPr>
          <p:spPr>
            <a:xfrm>
              <a:off x="5633299" y="4162953"/>
              <a:ext cx="1139050" cy="79421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D532D3F3-ABF6-B89C-4C75-727F84B6AE82}"/>
                </a:ext>
              </a:extLst>
            </p:cNvPr>
            <p:cNvSpPr/>
            <p:nvPr/>
          </p:nvSpPr>
          <p:spPr>
            <a:xfrm>
              <a:off x="5645719" y="3263367"/>
              <a:ext cx="1126630" cy="794218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095B5BC4-F0DB-A1D6-1DB6-22EACA71E85E}"/>
                </a:ext>
              </a:extLst>
            </p:cNvPr>
            <p:cNvSpPr/>
            <p:nvPr/>
          </p:nvSpPr>
          <p:spPr>
            <a:xfrm>
              <a:off x="7984412" y="4157147"/>
              <a:ext cx="999699" cy="79421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42CCC32F-AF83-E3FD-452B-8A1C89603C39}"/>
                </a:ext>
              </a:extLst>
            </p:cNvPr>
            <p:cNvSpPr/>
            <p:nvPr/>
          </p:nvSpPr>
          <p:spPr>
            <a:xfrm>
              <a:off x="7995314" y="3257562"/>
              <a:ext cx="988797" cy="794218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1" name="Picture 90" descr="Chart, scatter chart&#10;&#10;Description automatically generated">
              <a:extLst>
                <a:ext uri="{FF2B5EF4-FFF2-40B4-BE49-F238E27FC236}">
                  <a16:creationId xmlns:a16="http://schemas.microsoft.com/office/drawing/2014/main" id="{A5CFBD19-2B4C-C6F2-DAE5-752800C81C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55" r="52914" b="7319"/>
            <a:stretch/>
          </p:blipFill>
          <p:spPr>
            <a:xfrm>
              <a:off x="297886" y="5658445"/>
              <a:ext cx="2065697" cy="2118328"/>
            </a:xfrm>
            <a:prstGeom prst="rect">
              <a:avLst/>
            </a:prstGeom>
          </p:spPr>
        </p:pic>
        <p:pic>
          <p:nvPicPr>
            <p:cNvPr id="92" name="Picture 91" descr="Chart, histogram&#10;&#10;Description automatically generated">
              <a:extLst>
                <a:ext uri="{FF2B5EF4-FFF2-40B4-BE49-F238E27FC236}">
                  <a16:creationId xmlns:a16="http://schemas.microsoft.com/office/drawing/2014/main" id="{ED65F2C8-B938-1E0A-82BA-9C3564FEAD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054" b="7319"/>
            <a:stretch/>
          </p:blipFill>
          <p:spPr>
            <a:xfrm>
              <a:off x="6975329" y="5729814"/>
              <a:ext cx="2082920" cy="2039685"/>
            </a:xfrm>
            <a:prstGeom prst="rect">
              <a:avLst/>
            </a:prstGeom>
          </p:spPr>
        </p:pic>
        <p:pic>
          <p:nvPicPr>
            <p:cNvPr id="93" name="Picture 92" descr="Chart, scatter chart&#10;&#10;Description automatically generated">
              <a:extLst>
                <a:ext uri="{FF2B5EF4-FFF2-40B4-BE49-F238E27FC236}">
                  <a16:creationId xmlns:a16="http://schemas.microsoft.com/office/drawing/2014/main" id="{B8E98B1C-1415-5B88-7660-CC436A94BC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817" b="6362"/>
            <a:stretch/>
          </p:blipFill>
          <p:spPr>
            <a:xfrm>
              <a:off x="2521934" y="5660908"/>
              <a:ext cx="2165627" cy="2159883"/>
            </a:xfrm>
            <a:prstGeom prst="rect">
              <a:avLst/>
            </a:prstGeom>
          </p:spPr>
        </p:pic>
        <p:pic>
          <p:nvPicPr>
            <p:cNvPr id="94" name="Picture 93" descr="Chart, histogram&#10;&#10;Description automatically generated">
              <a:extLst>
                <a:ext uri="{FF2B5EF4-FFF2-40B4-BE49-F238E27FC236}">
                  <a16:creationId xmlns:a16="http://schemas.microsoft.com/office/drawing/2014/main" id="{B3E3ADA6-8F36-0B70-B348-1D09FDCB40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6" r="50719" b="6362"/>
            <a:stretch/>
          </p:blipFill>
          <p:spPr>
            <a:xfrm>
              <a:off x="4894333" y="5729815"/>
              <a:ext cx="2027458" cy="2022078"/>
            </a:xfrm>
            <a:prstGeom prst="rect">
              <a:avLst/>
            </a:prstGeom>
          </p:spPr>
        </p:pic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DEB3F8E8-4209-5333-8EAA-27DA5A4CCDCA}"/>
                </a:ext>
              </a:extLst>
            </p:cNvPr>
            <p:cNvSpPr txBox="1"/>
            <p:nvPr/>
          </p:nvSpPr>
          <p:spPr>
            <a:xfrm>
              <a:off x="118081" y="5425506"/>
              <a:ext cx="4056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E2EEA275-AE5E-1F94-637E-CC8BE2E41761}"/>
                </a:ext>
              </a:extLst>
            </p:cNvPr>
            <p:cNvSpPr txBox="1"/>
            <p:nvPr/>
          </p:nvSpPr>
          <p:spPr>
            <a:xfrm rot="16200000">
              <a:off x="2181251" y="6474422"/>
              <a:ext cx="8000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LIN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E8E07024-07C3-0DC4-8FDA-28EC3B10D8A5}"/>
                </a:ext>
              </a:extLst>
            </p:cNvPr>
            <p:cNvSpPr txBox="1"/>
            <p:nvPr/>
          </p:nvSpPr>
          <p:spPr>
            <a:xfrm>
              <a:off x="1071376" y="7648971"/>
              <a:ext cx="8263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YFP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65C5DC89-63E7-B1F0-E7D9-33F0988ED7AE}"/>
                </a:ext>
              </a:extLst>
            </p:cNvPr>
            <p:cNvSpPr txBox="1"/>
            <p:nvPr/>
          </p:nvSpPr>
          <p:spPr>
            <a:xfrm>
              <a:off x="3342254" y="7648971"/>
              <a:ext cx="8263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YFP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F4559F09-32C3-815A-5E82-E9B51079E79F}"/>
                </a:ext>
              </a:extLst>
            </p:cNvPr>
            <p:cNvSpPr txBox="1"/>
            <p:nvPr/>
          </p:nvSpPr>
          <p:spPr>
            <a:xfrm rot="16200000">
              <a:off x="4359982" y="6346671"/>
              <a:ext cx="8914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7A4E7ABB-F0FD-9AEC-8283-F199953585C9}"/>
                </a:ext>
              </a:extLst>
            </p:cNvPr>
            <p:cNvSpPr txBox="1"/>
            <p:nvPr/>
          </p:nvSpPr>
          <p:spPr>
            <a:xfrm>
              <a:off x="5681781" y="7648971"/>
              <a:ext cx="826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57A3FB8D-7457-2626-4D30-D32F52AE4EF7}"/>
                </a:ext>
              </a:extLst>
            </p:cNvPr>
            <p:cNvSpPr txBox="1"/>
            <p:nvPr/>
          </p:nvSpPr>
          <p:spPr>
            <a:xfrm rot="16200000">
              <a:off x="6544397" y="6357265"/>
              <a:ext cx="9126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C246B2FA-9DB3-50D4-9FA7-D74D1D9B8E38}"/>
                </a:ext>
              </a:extLst>
            </p:cNvPr>
            <p:cNvSpPr txBox="1"/>
            <p:nvPr/>
          </p:nvSpPr>
          <p:spPr>
            <a:xfrm>
              <a:off x="7931050" y="7648971"/>
              <a:ext cx="7662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8C7E379A-EC4B-C290-2432-38AB5631241F}"/>
                </a:ext>
              </a:extLst>
            </p:cNvPr>
            <p:cNvSpPr txBox="1"/>
            <p:nvPr/>
          </p:nvSpPr>
          <p:spPr>
            <a:xfrm rot="16200000">
              <a:off x="-128754" y="6477742"/>
              <a:ext cx="8000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LIN</a:t>
              </a:r>
            </a:p>
          </p:txBody>
        </p:sp>
        <p:pic>
          <p:nvPicPr>
            <p:cNvPr id="104" name="Picture 103" descr="Chart, scatter chart&#10;&#10;Description automatically generated">
              <a:extLst>
                <a:ext uri="{FF2B5EF4-FFF2-40B4-BE49-F238E27FC236}">
                  <a16:creationId xmlns:a16="http://schemas.microsoft.com/office/drawing/2014/main" id="{923E4E55-AECA-61E6-96FA-948646B606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40" r="51231" b="6935"/>
            <a:stretch/>
          </p:blipFill>
          <p:spPr>
            <a:xfrm>
              <a:off x="323927" y="8086695"/>
              <a:ext cx="2065698" cy="2044600"/>
            </a:xfrm>
            <a:prstGeom prst="rect">
              <a:avLst/>
            </a:prstGeom>
          </p:spPr>
        </p:pic>
        <p:pic>
          <p:nvPicPr>
            <p:cNvPr id="105" name="Picture 104" descr="Chart&#10;&#10;Description automatically generated">
              <a:extLst>
                <a:ext uri="{FF2B5EF4-FFF2-40B4-BE49-F238E27FC236}">
                  <a16:creationId xmlns:a16="http://schemas.microsoft.com/office/drawing/2014/main" id="{20C50121-C21F-CA83-25D4-490A4D2354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64" r="50521" b="7158"/>
            <a:stretch/>
          </p:blipFill>
          <p:spPr>
            <a:xfrm>
              <a:off x="4839095" y="8091610"/>
              <a:ext cx="2137935" cy="2039685"/>
            </a:xfrm>
            <a:prstGeom prst="rect">
              <a:avLst/>
            </a:prstGeom>
          </p:spPr>
        </p:pic>
        <p:pic>
          <p:nvPicPr>
            <p:cNvPr id="106" name="Picture 105" descr="Chart, scatter chart&#10;&#10;Description automatically generated">
              <a:extLst>
                <a:ext uri="{FF2B5EF4-FFF2-40B4-BE49-F238E27FC236}">
                  <a16:creationId xmlns:a16="http://schemas.microsoft.com/office/drawing/2014/main" id="{7AB65C80-9E43-CF8A-8DEE-3C0F22628C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53" b="6935"/>
            <a:stretch/>
          </p:blipFill>
          <p:spPr>
            <a:xfrm>
              <a:off x="2591234" y="8040428"/>
              <a:ext cx="2038221" cy="2044600"/>
            </a:xfrm>
            <a:prstGeom prst="rect">
              <a:avLst/>
            </a:prstGeom>
          </p:spPr>
        </p:pic>
        <p:pic>
          <p:nvPicPr>
            <p:cNvPr id="107" name="Picture 106" descr="Chart&#10;&#10;Description automatically generated">
              <a:extLst>
                <a:ext uri="{FF2B5EF4-FFF2-40B4-BE49-F238E27FC236}">
                  <a16:creationId xmlns:a16="http://schemas.microsoft.com/office/drawing/2014/main" id="{FA602999-B9DF-699B-CC39-141588F7FA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988" b="6935"/>
            <a:stretch/>
          </p:blipFill>
          <p:spPr>
            <a:xfrm>
              <a:off x="7032268" y="8086695"/>
              <a:ext cx="2038221" cy="2044599"/>
            </a:xfrm>
            <a:prstGeom prst="rect">
              <a:avLst/>
            </a:prstGeom>
          </p:spPr>
        </p:pic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1A316F19-80B6-7D5E-C560-268C9BC998CF}"/>
                </a:ext>
              </a:extLst>
            </p:cNvPr>
            <p:cNvSpPr txBox="1"/>
            <p:nvPr/>
          </p:nvSpPr>
          <p:spPr>
            <a:xfrm>
              <a:off x="104036" y="7904063"/>
              <a:ext cx="4056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)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B24C2816-22D2-3281-6D64-D3864B88B8AC}"/>
                </a:ext>
              </a:extLst>
            </p:cNvPr>
            <p:cNvSpPr txBox="1"/>
            <p:nvPr/>
          </p:nvSpPr>
          <p:spPr>
            <a:xfrm rot="16200000">
              <a:off x="2132768" y="8849820"/>
              <a:ext cx="8000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LIN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D242AB3D-2A57-D84B-D385-0F6B261BED9D}"/>
                </a:ext>
              </a:extLst>
            </p:cNvPr>
            <p:cNvSpPr txBox="1"/>
            <p:nvPr/>
          </p:nvSpPr>
          <p:spPr>
            <a:xfrm>
              <a:off x="1022893" y="10024368"/>
              <a:ext cx="8263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YFP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1E697042-D08A-470B-CEF4-364F2C898F6A}"/>
                </a:ext>
              </a:extLst>
            </p:cNvPr>
            <p:cNvSpPr txBox="1"/>
            <p:nvPr/>
          </p:nvSpPr>
          <p:spPr>
            <a:xfrm>
              <a:off x="3293770" y="10024368"/>
              <a:ext cx="8263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YFP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DD67BDA0-05A9-E864-18FF-67ADE5CCBA56}"/>
                </a:ext>
              </a:extLst>
            </p:cNvPr>
            <p:cNvSpPr txBox="1"/>
            <p:nvPr/>
          </p:nvSpPr>
          <p:spPr>
            <a:xfrm rot="16200000">
              <a:off x="4357179" y="8767749"/>
              <a:ext cx="8000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BCCB23B4-9594-D8E9-B732-DE5332636811}"/>
                </a:ext>
              </a:extLst>
            </p:cNvPr>
            <p:cNvSpPr txBox="1"/>
            <p:nvPr/>
          </p:nvSpPr>
          <p:spPr>
            <a:xfrm>
              <a:off x="5633298" y="10024369"/>
              <a:ext cx="826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53BEAAD1-2334-9F20-505E-949B2F1263EE}"/>
                </a:ext>
              </a:extLst>
            </p:cNvPr>
            <p:cNvSpPr txBox="1"/>
            <p:nvPr/>
          </p:nvSpPr>
          <p:spPr>
            <a:xfrm rot="16200000">
              <a:off x="6527949" y="8764697"/>
              <a:ext cx="8485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636B07D0-09DD-0FAC-5216-B45B97058780}"/>
                </a:ext>
              </a:extLst>
            </p:cNvPr>
            <p:cNvSpPr txBox="1"/>
            <p:nvPr/>
          </p:nvSpPr>
          <p:spPr>
            <a:xfrm>
              <a:off x="7882566" y="10024369"/>
              <a:ext cx="7662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55597582-B324-5607-6362-7610F8D89E92}"/>
                </a:ext>
              </a:extLst>
            </p:cNvPr>
            <p:cNvSpPr txBox="1"/>
            <p:nvPr/>
          </p:nvSpPr>
          <p:spPr>
            <a:xfrm rot="16200000">
              <a:off x="-177237" y="8853140"/>
              <a:ext cx="8000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LIN</a:t>
              </a:r>
            </a:p>
          </p:txBody>
        </p:sp>
        <p:sp>
          <p:nvSpPr>
            <p:cNvPr id="117" name="Freeform: Shape 93">
              <a:extLst>
                <a:ext uri="{FF2B5EF4-FFF2-40B4-BE49-F238E27FC236}">
                  <a16:creationId xmlns:a16="http://schemas.microsoft.com/office/drawing/2014/main" id="{89951375-2762-59B5-41F8-6E092C65535C}"/>
                </a:ext>
              </a:extLst>
            </p:cNvPr>
            <p:cNvSpPr/>
            <p:nvPr/>
          </p:nvSpPr>
          <p:spPr>
            <a:xfrm>
              <a:off x="1571322" y="6619677"/>
              <a:ext cx="743840" cy="891461"/>
            </a:xfrm>
            <a:custGeom>
              <a:avLst/>
              <a:gdLst>
                <a:gd name="connsiteX0" fmla="*/ 0 w 1063869"/>
                <a:gd name="connsiteY0" fmla="*/ 1143000 h 1151792"/>
                <a:gd name="connsiteX1" fmla="*/ 272562 w 1063869"/>
                <a:gd name="connsiteY1" fmla="*/ 369276 h 1151792"/>
                <a:gd name="connsiteX2" fmla="*/ 553916 w 1063869"/>
                <a:gd name="connsiteY2" fmla="*/ 8792 h 1151792"/>
                <a:gd name="connsiteX3" fmla="*/ 1037493 w 1063869"/>
                <a:gd name="connsiteY3" fmla="*/ 0 h 1151792"/>
                <a:gd name="connsiteX4" fmla="*/ 1063869 w 1063869"/>
                <a:gd name="connsiteY4" fmla="*/ 1151792 h 1151792"/>
                <a:gd name="connsiteX5" fmla="*/ 0 w 1063869"/>
                <a:gd name="connsiteY5" fmla="*/ 1143000 h 1151792"/>
                <a:gd name="connsiteX0" fmla="*/ 0 w 1063869"/>
                <a:gd name="connsiteY0" fmla="*/ 1143000 h 1151792"/>
                <a:gd name="connsiteX1" fmla="*/ 236191 w 1063869"/>
                <a:gd name="connsiteY1" fmla="*/ 342068 h 1151792"/>
                <a:gd name="connsiteX2" fmla="*/ 553916 w 1063869"/>
                <a:gd name="connsiteY2" fmla="*/ 8792 h 1151792"/>
                <a:gd name="connsiteX3" fmla="*/ 1037493 w 1063869"/>
                <a:gd name="connsiteY3" fmla="*/ 0 h 1151792"/>
                <a:gd name="connsiteX4" fmla="*/ 1063869 w 1063869"/>
                <a:gd name="connsiteY4" fmla="*/ 1151792 h 1151792"/>
                <a:gd name="connsiteX5" fmla="*/ 0 w 1063869"/>
                <a:gd name="connsiteY5" fmla="*/ 1143000 h 1151792"/>
                <a:gd name="connsiteX0" fmla="*/ 0 w 1128422"/>
                <a:gd name="connsiteY0" fmla="*/ 1152069 h 1160861"/>
                <a:gd name="connsiteX1" fmla="*/ 236191 w 1128422"/>
                <a:gd name="connsiteY1" fmla="*/ 351137 h 1160861"/>
                <a:gd name="connsiteX2" fmla="*/ 553916 w 1128422"/>
                <a:gd name="connsiteY2" fmla="*/ 17861 h 1160861"/>
                <a:gd name="connsiteX3" fmla="*/ 1128422 w 1128422"/>
                <a:gd name="connsiteY3" fmla="*/ 0 h 1160861"/>
                <a:gd name="connsiteX4" fmla="*/ 1063869 w 1128422"/>
                <a:gd name="connsiteY4" fmla="*/ 1160861 h 1160861"/>
                <a:gd name="connsiteX5" fmla="*/ 0 w 1128422"/>
                <a:gd name="connsiteY5" fmla="*/ 1152069 h 1160861"/>
                <a:gd name="connsiteX0" fmla="*/ 0 w 1128422"/>
                <a:gd name="connsiteY0" fmla="*/ 1152069 h 1152069"/>
                <a:gd name="connsiteX1" fmla="*/ 236191 w 1128422"/>
                <a:gd name="connsiteY1" fmla="*/ 351137 h 1152069"/>
                <a:gd name="connsiteX2" fmla="*/ 553916 w 1128422"/>
                <a:gd name="connsiteY2" fmla="*/ 17861 h 1152069"/>
                <a:gd name="connsiteX3" fmla="*/ 1128422 w 1128422"/>
                <a:gd name="connsiteY3" fmla="*/ 0 h 1152069"/>
                <a:gd name="connsiteX4" fmla="*/ 1118427 w 1128422"/>
                <a:gd name="connsiteY4" fmla="*/ 1142722 h 1152069"/>
                <a:gd name="connsiteX5" fmla="*/ 0 w 1128422"/>
                <a:gd name="connsiteY5" fmla="*/ 1152069 h 1152069"/>
                <a:gd name="connsiteX0" fmla="*/ 0 w 1136796"/>
                <a:gd name="connsiteY0" fmla="*/ 1152069 h 1160754"/>
                <a:gd name="connsiteX1" fmla="*/ 236191 w 1136796"/>
                <a:gd name="connsiteY1" fmla="*/ 351137 h 1160754"/>
                <a:gd name="connsiteX2" fmla="*/ 553916 w 1136796"/>
                <a:gd name="connsiteY2" fmla="*/ 17861 h 1160754"/>
                <a:gd name="connsiteX3" fmla="*/ 1128422 w 1136796"/>
                <a:gd name="connsiteY3" fmla="*/ 0 h 1160754"/>
                <a:gd name="connsiteX4" fmla="*/ 1136298 w 1136796"/>
                <a:gd name="connsiteY4" fmla="*/ 1160754 h 1160754"/>
                <a:gd name="connsiteX5" fmla="*/ 0 w 1136796"/>
                <a:gd name="connsiteY5" fmla="*/ 1152069 h 116075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36796" h="1160754">
                  <a:moveTo>
                    <a:pt x="0" y="1152069"/>
                  </a:moveTo>
                  <a:lnTo>
                    <a:pt x="236191" y="351137"/>
                  </a:lnTo>
                  <a:lnTo>
                    <a:pt x="553916" y="17861"/>
                  </a:lnTo>
                  <a:lnTo>
                    <a:pt x="1128422" y="0"/>
                  </a:lnTo>
                  <a:cubicBezTo>
                    <a:pt x="1125090" y="380907"/>
                    <a:pt x="1139630" y="779847"/>
                    <a:pt x="1136298" y="1160754"/>
                  </a:cubicBezTo>
                  <a:lnTo>
                    <a:pt x="0" y="1152069"/>
                  </a:lnTo>
                  <a:close/>
                </a:path>
              </a:pathLst>
            </a:cu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Oval 117">
              <a:extLst>
                <a:ext uri="{FF2B5EF4-FFF2-40B4-BE49-F238E27FC236}">
                  <a16:creationId xmlns:a16="http://schemas.microsoft.com/office/drawing/2014/main" id="{F8B250F7-808F-B55C-9918-A3D9BB49E441}"/>
                </a:ext>
              </a:extLst>
            </p:cNvPr>
            <p:cNvSpPr/>
            <p:nvPr/>
          </p:nvSpPr>
          <p:spPr>
            <a:xfrm>
              <a:off x="8051445" y="6794504"/>
              <a:ext cx="862812" cy="63653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Oval 118">
              <a:extLst>
                <a:ext uri="{FF2B5EF4-FFF2-40B4-BE49-F238E27FC236}">
                  <a16:creationId xmlns:a16="http://schemas.microsoft.com/office/drawing/2014/main" id="{67A722CB-D985-DC21-8DA8-62CAE5E71705}"/>
                </a:ext>
              </a:extLst>
            </p:cNvPr>
            <p:cNvSpPr/>
            <p:nvPr/>
          </p:nvSpPr>
          <p:spPr>
            <a:xfrm>
              <a:off x="8055675" y="6071364"/>
              <a:ext cx="862812" cy="63653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Oval 119">
              <a:extLst>
                <a:ext uri="{FF2B5EF4-FFF2-40B4-BE49-F238E27FC236}">
                  <a16:creationId xmlns:a16="http://schemas.microsoft.com/office/drawing/2014/main" id="{220EF730-B235-42BB-794D-817311109023}"/>
                </a:ext>
              </a:extLst>
            </p:cNvPr>
            <p:cNvSpPr/>
            <p:nvPr/>
          </p:nvSpPr>
          <p:spPr>
            <a:xfrm>
              <a:off x="5856434" y="6794504"/>
              <a:ext cx="862812" cy="63653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Oval 120">
              <a:extLst>
                <a:ext uri="{FF2B5EF4-FFF2-40B4-BE49-F238E27FC236}">
                  <a16:creationId xmlns:a16="http://schemas.microsoft.com/office/drawing/2014/main" id="{3156CD86-0356-6297-6D8D-660B50B8DDB1}"/>
                </a:ext>
              </a:extLst>
            </p:cNvPr>
            <p:cNvSpPr/>
            <p:nvPr/>
          </p:nvSpPr>
          <p:spPr>
            <a:xfrm>
              <a:off x="5860664" y="6071364"/>
              <a:ext cx="862812" cy="636530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Freeform: Shape 93">
              <a:extLst>
                <a:ext uri="{FF2B5EF4-FFF2-40B4-BE49-F238E27FC236}">
                  <a16:creationId xmlns:a16="http://schemas.microsoft.com/office/drawing/2014/main" id="{0C2D6430-CD2D-EC8B-760A-C223F6803378}"/>
                </a:ext>
              </a:extLst>
            </p:cNvPr>
            <p:cNvSpPr/>
            <p:nvPr/>
          </p:nvSpPr>
          <p:spPr>
            <a:xfrm>
              <a:off x="3865871" y="6647691"/>
              <a:ext cx="743840" cy="891461"/>
            </a:xfrm>
            <a:custGeom>
              <a:avLst/>
              <a:gdLst>
                <a:gd name="connsiteX0" fmla="*/ 0 w 1063869"/>
                <a:gd name="connsiteY0" fmla="*/ 1143000 h 1151792"/>
                <a:gd name="connsiteX1" fmla="*/ 272562 w 1063869"/>
                <a:gd name="connsiteY1" fmla="*/ 369276 h 1151792"/>
                <a:gd name="connsiteX2" fmla="*/ 553916 w 1063869"/>
                <a:gd name="connsiteY2" fmla="*/ 8792 h 1151792"/>
                <a:gd name="connsiteX3" fmla="*/ 1037493 w 1063869"/>
                <a:gd name="connsiteY3" fmla="*/ 0 h 1151792"/>
                <a:gd name="connsiteX4" fmla="*/ 1063869 w 1063869"/>
                <a:gd name="connsiteY4" fmla="*/ 1151792 h 1151792"/>
                <a:gd name="connsiteX5" fmla="*/ 0 w 1063869"/>
                <a:gd name="connsiteY5" fmla="*/ 1143000 h 1151792"/>
                <a:gd name="connsiteX0" fmla="*/ 0 w 1063869"/>
                <a:gd name="connsiteY0" fmla="*/ 1143000 h 1151792"/>
                <a:gd name="connsiteX1" fmla="*/ 236191 w 1063869"/>
                <a:gd name="connsiteY1" fmla="*/ 342068 h 1151792"/>
                <a:gd name="connsiteX2" fmla="*/ 553916 w 1063869"/>
                <a:gd name="connsiteY2" fmla="*/ 8792 h 1151792"/>
                <a:gd name="connsiteX3" fmla="*/ 1037493 w 1063869"/>
                <a:gd name="connsiteY3" fmla="*/ 0 h 1151792"/>
                <a:gd name="connsiteX4" fmla="*/ 1063869 w 1063869"/>
                <a:gd name="connsiteY4" fmla="*/ 1151792 h 1151792"/>
                <a:gd name="connsiteX5" fmla="*/ 0 w 1063869"/>
                <a:gd name="connsiteY5" fmla="*/ 1143000 h 1151792"/>
                <a:gd name="connsiteX0" fmla="*/ 0 w 1128422"/>
                <a:gd name="connsiteY0" fmla="*/ 1152069 h 1160861"/>
                <a:gd name="connsiteX1" fmla="*/ 236191 w 1128422"/>
                <a:gd name="connsiteY1" fmla="*/ 351137 h 1160861"/>
                <a:gd name="connsiteX2" fmla="*/ 553916 w 1128422"/>
                <a:gd name="connsiteY2" fmla="*/ 17861 h 1160861"/>
                <a:gd name="connsiteX3" fmla="*/ 1128422 w 1128422"/>
                <a:gd name="connsiteY3" fmla="*/ 0 h 1160861"/>
                <a:gd name="connsiteX4" fmla="*/ 1063869 w 1128422"/>
                <a:gd name="connsiteY4" fmla="*/ 1160861 h 1160861"/>
                <a:gd name="connsiteX5" fmla="*/ 0 w 1128422"/>
                <a:gd name="connsiteY5" fmla="*/ 1152069 h 1160861"/>
                <a:gd name="connsiteX0" fmla="*/ 0 w 1128422"/>
                <a:gd name="connsiteY0" fmla="*/ 1152069 h 1152069"/>
                <a:gd name="connsiteX1" fmla="*/ 236191 w 1128422"/>
                <a:gd name="connsiteY1" fmla="*/ 351137 h 1152069"/>
                <a:gd name="connsiteX2" fmla="*/ 553916 w 1128422"/>
                <a:gd name="connsiteY2" fmla="*/ 17861 h 1152069"/>
                <a:gd name="connsiteX3" fmla="*/ 1128422 w 1128422"/>
                <a:gd name="connsiteY3" fmla="*/ 0 h 1152069"/>
                <a:gd name="connsiteX4" fmla="*/ 1118427 w 1128422"/>
                <a:gd name="connsiteY4" fmla="*/ 1142722 h 1152069"/>
                <a:gd name="connsiteX5" fmla="*/ 0 w 1128422"/>
                <a:gd name="connsiteY5" fmla="*/ 1152069 h 1152069"/>
                <a:gd name="connsiteX0" fmla="*/ 0 w 1136796"/>
                <a:gd name="connsiteY0" fmla="*/ 1152069 h 1160754"/>
                <a:gd name="connsiteX1" fmla="*/ 236191 w 1136796"/>
                <a:gd name="connsiteY1" fmla="*/ 351137 h 1160754"/>
                <a:gd name="connsiteX2" fmla="*/ 553916 w 1136796"/>
                <a:gd name="connsiteY2" fmla="*/ 17861 h 1160754"/>
                <a:gd name="connsiteX3" fmla="*/ 1128422 w 1136796"/>
                <a:gd name="connsiteY3" fmla="*/ 0 h 1160754"/>
                <a:gd name="connsiteX4" fmla="*/ 1136298 w 1136796"/>
                <a:gd name="connsiteY4" fmla="*/ 1160754 h 1160754"/>
                <a:gd name="connsiteX5" fmla="*/ 0 w 1136796"/>
                <a:gd name="connsiteY5" fmla="*/ 1152069 h 116075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136796" h="1160754">
                  <a:moveTo>
                    <a:pt x="0" y="1152069"/>
                  </a:moveTo>
                  <a:lnTo>
                    <a:pt x="236191" y="351137"/>
                  </a:lnTo>
                  <a:lnTo>
                    <a:pt x="553916" y="17861"/>
                  </a:lnTo>
                  <a:lnTo>
                    <a:pt x="1128422" y="0"/>
                  </a:lnTo>
                  <a:cubicBezTo>
                    <a:pt x="1125090" y="380907"/>
                    <a:pt x="1139630" y="779847"/>
                    <a:pt x="1136298" y="1160754"/>
                  </a:cubicBezTo>
                  <a:lnTo>
                    <a:pt x="0" y="1152069"/>
                  </a:lnTo>
                  <a:close/>
                </a:path>
              </a:pathLst>
            </a:cu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Freeform: Shape 24">
              <a:extLst>
                <a:ext uri="{FF2B5EF4-FFF2-40B4-BE49-F238E27FC236}">
                  <a16:creationId xmlns:a16="http://schemas.microsoft.com/office/drawing/2014/main" id="{8860FE4B-619D-E381-0695-040234B5E90B}"/>
                </a:ext>
              </a:extLst>
            </p:cNvPr>
            <p:cNvSpPr/>
            <p:nvPr/>
          </p:nvSpPr>
          <p:spPr>
            <a:xfrm>
              <a:off x="1174541" y="8942192"/>
              <a:ext cx="947441" cy="923133"/>
            </a:xfrm>
            <a:custGeom>
              <a:avLst/>
              <a:gdLst>
                <a:gd name="connsiteX0" fmla="*/ 0 w 1063869"/>
                <a:gd name="connsiteY0" fmla="*/ 1143000 h 1151792"/>
                <a:gd name="connsiteX1" fmla="*/ 272562 w 1063869"/>
                <a:gd name="connsiteY1" fmla="*/ 369276 h 1151792"/>
                <a:gd name="connsiteX2" fmla="*/ 553916 w 1063869"/>
                <a:gd name="connsiteY2" fmla="*/ 8792 h 1151792"/>
                <a:gd name="connsiteX3" fmla="*/ 1037493 w 1063869"/>
                <a:gd name="connsiteY3" fmla="*/ 0 h 1151792"/>
                <a:gd name="connsiteX4" fmla="*/ 1063869 w 1063869"/>
                <a:gd name="connsiteY4" fmla="*/ 1151792 h 1151792"/>
                <a:gd name="connsiteX5" fmla="*/ 0 w 1063869"/>
                <a:gd name="connsiteY5" fmla="*/ 1143000 h 1151792"/>
                <a:gd name="connsiteX0" fmla="*/ 0 w 1063869"/>
                <a:gd name="connsiteY0" fmla="*/ 1143000 h 1151792"/>
                <a:gd name="connsiteX1" fmla="*/ 236191 w 1063869"/>
                <a:gd name="connsiteY1" fmla="*/ 342068 h 1151792"/>
                <a:gd name="connsiteX2" fmla="*/ 553916 w 1063869"/>
                <a:gd name="connsiteY2" fmla="*/ 8792 h 1151792"/>
                <a:gd name="connsiteX3" fmla="*/ 1037493 w 1063869"/>
                <a:gd name="connsiteY3" fmla="*/ 0 h 1151792"/>
                <a:gd name="connsiteX4" fmla="*/ 1063869 w 1063869"/>
                <a:gd name="connsiteY4" fmla="*/ 1151792 h 1151792"/>
                <a:gd name="connsiteX5" fmla="*/ 0 w 1063869"/>
                <a:gd name="connsiteY5" fmla="*/ 1143000 h 1151792"/>
                <a:gd name="connsiteX0" fmla="*/ 0 w 1128422"/>
                <a:gd name="connsiteY0" fmla="*/ 1152069 h 1160861"/>
                <a:gd name="connsiteX1" fmla="*/ 236191 w 1128422"/>
                <a:gd name="connsiteY1" fmla="*/ 351137 h 1160861"/>
                <a:gd name="connsiteX2" fmla="*/ 553916 w 1128422"/>
                <a:gd name="connsiteY2" fmla="*/ 17861 h 1160861"/>
                <a:gd name="connsiteX3" fmla="*/ 1128422 w 1128422"/>
                <a:gd name="connsiteY3" fmla="*/ 0 h 1160861"/>
                <a:gd name="connsiteX4" fmla="*/ 1063869 w 1128422"/>
                <a:gd name="connsiteY4" fmla="*/ 1160861 h 1160861"/>
                <a:gd name="connsiteX5" fmla="*/ 0 w 1128422"/>
                <a:gd name="connsiteY5" fmla="*/ 1152069 h 1160861"/>
                <a:gd name="connsiteX0" fmla="*/ 0 w 1128422"/>
                <a:gd name="connsiteY0" fmla="*/ 1152069 h 1152069"/>
                <a:gd name="connsiteX1" fmla="*/ 236191 w 1128422"/>
                <a:gd name="connsiteY1" fmla="*/ 351137 h 1152069"/>
                <a:gd name="connsiteX2" fmla="*/ 553916 w 1128422"/>
                <a:gd name="connsiteY2" fmla="*/ 17861 h 1152069"/>
                <a:gd name="connsiteX3" fmla="*/ 1128422 w 1128422"/>
                <a:gd name="connsiteY3" fmla="*/ 0 h 1152069"/>
                <a:gd name="connsiteX4" fmla="*/ 1118427 w 1128422"/>
                <a:gd name="connsiteY4" fmla="*/ 1142722 h 1152069"/>
                <a:gd name="connsiteX5" fmla="*/ 0 w 1128422"/>
                <a:gd name="connsiteY5" fmla="*/ 1152069 h 1152069"/>
                <a:gd name="connsiteX0" fmla="*/ 0 w 1209448"/>
                <a:gd name="connsiteY0" fmla="*/ 1152069 h 1160860"/>
                <a:gd name="connsiteX1" fmla="*/ 236191 w 1209448"/>
                <a:gd name="connsiteY1" fmla="*/ 351137 h 1160860"/>
                <a:gd name="connsiteX2" fmla="*/ 553916 w 1209448"/>
                <a:gd name="connsiteY2" fmla="*/ 17861 h 1160860"/>
                <a:gd name="connsiteX3" fmla="*/ 1128422 w 1209448"/>
                <a:gd name="connsiteY3" fmla="*/ 0 h 1160860"/>
                <a:gd name="connsiteX4" fmla="*/ 1209355 w 1209448"/>
                <a:gd name="connsiteY4" fmla="*/ 1160860 h 1160860"/>
                <a:gd name="connsiteX5" fmla="*/ 0 w 1209448"/>
                <a:gd name="connsiteY5" fmla="*/ 1152069 h 1160860"/>
                <a:gd name="connsiteX0" fmla="*/ 0 w 1209845"/>
                <a:gd name="connsiteY0" fmla="*/ 1161139 h 1169930"/>
                <a:gd name="connsiteX1" fmla="*/ 236191 w 1209845"/>
                <a:gd name="connsiteY1" fmla="*/ 360207 h 1169930"/>
                <a:gd name="connsiteX2" fmla="*/ 553916 w 1209845"/>
                <a:gd name="connsiteY2" fmla="*/ 26931 h 1169930"/>
                <a:gd name="connsiteX3" fmla="*/ 1201165 w 1209845"/>
                <a:gd name="connsiteY3" fmla="*/ 0 h 1169930"/>
                <a:gd name="connsiteX4" fmla="*/ 1209355 w 1209845"/>
                <a:gd name="connsiteY4" fmla="*/ 1169930 h 1169930"/>
                <a:gd name="connsiteX5" fmla="*/ 0 w 1209845"/>
                <a:gd name="connsiteY5" fmla="*/ 1161139 h 1169930"/>
                <a:gd name="connsiteX0" fmla="*/ 0 w 1209845"/>
                <a:gd name="connsiteY0" fmla="*/ 1188345 h 1188345"/>
                <a:gd name="connsiteX1" fmla="*/ 236191 w 1209845"/>
                <a:gd name="connsiteY1" fmla="*/ 360207 h 1188345"/>
                <a:gd name="connsiteX2" fmla="*/ 553916 w 1209845"/>
                <a:gd name="connsiteY2" fmla="*/ 26931 h 1188345"/>
                <a:gd name="connsiteX3" fmla="*/ 1201165 w 1209845"/>
                <a:gd name="connsiteY3" fmla="*/ 0 h 1188345"/>
                <a:gd name="connsiteX4" fmla="*/ 1209355 w 1209845"/>
                <a:gd name="connsiteY4" fmla="*/ 1169930 h 1188345"/>
                <a:gd name="connsiteX5" fmla="*/ 0 w 1209845"/>
                <a:gd name="connsiteY5" fmla="*/ 1188345 h 1188345"/>
                <a:gd name="connsiteX0" fmla="*/ 0 w 1218766"/>
                <a:gd name="connsiteY0" fmla="*/ 1188345 h 1188345"/>
                <a:gd name="connsiteX1" fmla="*/ 236191 w 1218766"/>
                <a:gd name="connsiteY1" fmla="*/ 360207 h 1188345"/>
                <a:gd name="connsiteX2" fmla="*/ 553916 w 1218766"/>
                <a:gd name="connsiteY2" fmla="*/ 26931 h 1188345"/>
                <a:gd name="connsiteX3" fmla="*/ 1201165 w 1218766"/>
                <a:gd name="connsiteY3" fmla="*/ 0 h 1188345"/>
                <a:gd name="connsiteX4" fmla="*/ 1218448 w 1218766"/>
                <a:gd name="connsiteY4" fmla="*/ 1188069 h 1188345"/>
                <a:gd name="connsiteX5" fmla="*/ 0 w 1218766"/>
                <a:gd name="connsiteY5" fmla="*/ 1188345 h 11883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218766" h="1188345">
                  <a:moveTo>
                    <a:pt x="0" y="1188345"/>
                  </a:moveTo>
                  <a:lnTo>
                    <a:pt x="236191" y="360207"/>
                  </a:lnTo>
                  <a:lnTo>
                    <a:pt x="553916" y="26931"/>
                  </a:lnTo>
                  <a:lnTo>
                    <a:pt x="1201165" y="0"/>
                  </a:lnTo>
                  <a:cubicBezTo>
                    <a:pt x="1197833" y="380907"/>
                    <a:pt x="1221780" y="807162"/>
                    <a:pt x="1218448" y="1188069"/>
                  </a:cubicBezTo>
                  <a:lnTo>
                    <a:pt x="0" y="1188345"/>
                  </a:lnTo>
                  <a:close/>
                </a:path>
              </a:pathLst>
            </a:cu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Freeform: Shape 24">
              <a:extLst>
                <a:ext uri="{FF2B5EF4-FFF2-40B4-BE49-F238E27FC236}">
                  <a16:creationId xmlns:a16="http://schemas.microsoft.com/office/drawing/2014/main" id="{D8D696EF-A334-E5A5-A31D-A586644EB6E9}"/>
                </a:ext>
              </a:extLst>
            </p:cNvPr>
            <p:cNvSpPr/>
            <p:nvPr/>
          </p:nvSpPr>
          <p:spPr>
            <a:xfrm>
              <a:off x="3437103" y="8937870"/>
              <a:ext cx="947441" cy="923133"/>
            </a:xfrm>
            <a:custGeom>
              <a:avLst/>
              <a:gdLst>
                <a:gd name="connsiteX0" fmla="*/ 0 w 1063869"/>
                <a:gd name="connsiteY0" fmla="*/ 1143000 h 1151792"/>
                <a:gd name="connsiteX1" fmla="*/ 272562 w 1063869"/>
                <a:gd name="connsiteY1" fmla="*/ 369276 h 1151792"/>
                <a:gd name="connsiteX2" fmla="*/ 553916 w 1063869"/>
                <a:gd name="connsiteY2" fmla="*/ 8792 h 1151792"/>
                <a:gd name="connsiteX3" fmla="*/ 1037493 w 1063869"/>
                <a:gd name="connsiteY3" fmla="*/ 0 h 1151792"/>
                <a:gd name="connsiteX4" fmla="*/ 1063869 w 1063869"/>
                <a:gd name="connsiteY4" fmla="*/ 1151792 h 1151792"/>
                <a:gd name="connsiteX5" fmla="*/ 0 w 1063869"/>
                <a:gd name="connsiteY5" fmla="*/ 1143000 h 1151792"/>
                <a:gd name="connsiteX0" fmla="*/ 0 w 1063869"/>
                <a:gd name="connsiteY0" fmla="*/ 1143000 h 1151792"/>
                <a:gd name="connsiteX1" fmla="*/ 236191 w 1063869"/>
                <a:gd name="connsiteY1" fmla="*/ 342068 h 1151792"/>
                <a:gd name="connsiteX2" fmla="*/ 553916 w 1063869"/>
                <a:gd name="connsiteY2" fmla="*/ 8792 h 1151792"/>
                <a:gd name="connsiteX3" fmla="*/ 1037493 w 1063869"/>
                <a:gd name="connsiteY3" fmla="*/ 0 h 1151792"/>
                <a:gd name="connsiteX4" fmla="*/ 1063869 w 1063869"/>
                <a:gd name="connsiteY4" fmla="*/ 1151792 h 1151792"/>
                <a:gd name="connsiteX5" fmla="*/ 0 w 1063869"/>
                <a:gd name="connsiteY5" fmla="*/ 1143000 h 1151792"/>
                <a:gd name="connsiteX0" fmla="*/ 0 w 1128422"/>
                <a:gd name="connsiteY0" fmla="*/ 1152069 h 1160861"/>
                <a:gd name="connsiteX1" fmla="*/ 236191 w 1128422"/>
                <a:gd name="connsiteY1" fmla="*/ 351137 h 1160861"/>
                <a:gd name="connsiteX2" fmla="*/ 553916 w 1128422"/>
                <a:gd name="connsiteY2" fmla="*/ 17861 h 1160861"/>
                <a:gd name="connsiteX3" fmla="*/ 1128422 w 1128422"/>
                <a:gd name="connsiteY3" fmla="*/ 0 h 1160861"/>
                <a:gd name="connsiteX4" fmla="*/ 1063869 w 1128422"/>
                <a:gd name="connsiteY4" fmla="*/ 1160861 h 1160861"/>
                <a:gd name="connsiteX5" fmla="*/ 0 w 1128422"/>
                <a:gd name="connsiteY5" fmla="*/ 1152069 h 1160861"/>
                <a:gd name="connsiteX0" fmla="*/ 0 w 1128422"/>
                <a:gd name="connsiteY0" fmla="*/ 1152069 h 1152069"/>
                <a:gd name="connsiteX1" fmla="*/ 236191 w 1128422"/>
                <a:gd name="connsiteY1" fmla="*/ 351137 h 1152069"/>
                <a:gd name="connsiteX2" fmla="*/ 553916 w 1128422"/>
                <a:gd name="connsiteY2" fmla="*/ 17861 h 1152069"/>
                <a:gd name="connsiteX3" fmla="*/ 1128422 w 1128422"/>
                <a:gd name="connsiteY3" fmla="*/ 0 h 1152069"/>
                <a:gd name="connsiteX4" fmla="*/ 1118427 w 1128422"/>
                <a:gd name="connsiteY4" fmla="*/ 1142722 h 1152069"/>
                <a:gd name="connsiteX5" fmla="*/ 0 w 1128422"/>
                <a:gd name="connsiteY5" fmla="*/ 1152069 h 1152069"/>
                <a:gd name="connsiteX0" fmla="*/ 0 w 1209448"/>
                <a:gd name="connsiteY0" fmla="*/ 1152069 h 1160860"/>
                <a:gd name="connsiteX1" fmla="*/ 236191 w 1209448"/>
                <a:gd name="connsiteY1" fmla="*/ 351137 h 1160860"/>
                <a:gd name="connsiteX2" fmla="*/ 553916 w 1209448"/>
                <a:gd name="connsiteY2" fmla="*/ 17861 h 1160860"/>
                <a:gd name="connsiteX3" fmla="*/ 1128422 w 1209448"/>
                <a:gd name="connsiteY3" fmla="*/ 0 h 1160860"/>
                <a:gd name="connsiteX4" fmla="*/ 1209355 w 1209448"/>
                <a:gd name="connsiteY4" fmla="*/ 1160860 h 1160860"/>
                <a:gd name="connsiteX5" fmla="*/ 0 w 1209448"/>
                <a:gd name="connsiteY5" fmla="*/ 1152069 h 1160860"/>
                <a:gd name="connsiteX0" fmla="*/ 0 w 1209845"/>
                <a:gd name="connsiteY0" fmla="*/ 1161139 h 1169930"/>
                <a:gd name="connsiteX1" fmla="*/ 236191 w 1209845"/>
                <a:gd name="connsiteY1" fmla="*/ 360207 h 1169930"/>
                <a:gd name="connsiteX2" fmla="*/ 553916 w 1209845"/>
                <a:gd name="connsiteY2" fmla="*/ 26931 h 1169930"/>
                <a:gd name="connsiteX3" fmla="*/ 1201165 w 1209845"/>
                <a:gd name="connsiteY3" fmla="*/ 0 h 1169930"/>
                <a:gd name="connsiteX4" fmla="*/ 1209355 w 1209845"/>
                <a:gd name="connsiteY4" fmla="*/ 1169930 h 1169930"/>
                <a:gd name="connsiteX5" fmla="*/ 0 w 1209845"/>
                <a:gd name="connsiteY5" fmla="*/ 1161139 h 1169930"/>
                <a:gd name="connsiteX0" fmla="*/ 0 w 1209845"/>
                <a:gd name="connsiteY0" fmla="*/ 1188345 h 1188345"/>
                <a:gd name="connsiteX1" fmla="*/ 236191 w 1209845"/>
                <a:gd name="connsiteY1" fmla="*/ 360207 h 1188345"/>
                <a:gd name="connsiteX2" fmla="*/ 553916 w 1209845"/>
                <a:gd name="connsiteY2" fmla="*/ 26931 h 1188345"/>
                <a:gd name="connsiteX3" fmla="*/ 1201165 w 1209845"/>
                <a:gd name="connsiteY3" fmla="*/ 0 h 1188345"/>
                <a:gd name="connsiteX4" fmla="*/ 1209355 w 1209845"/>
                <a:gd name="connsiteY4" fmla="*/ 1169930 h 1188345"/>
                <a:gd name="connsiteX5" fmla="*/ 0 w 1209845"/>
                <a:gd name="connsiteY5" fmla="*/ 1188345 h 1188345"/>
                <a:gd name="connsiteX0" fmla="*/ 0 w 1218766"/>
                <a:gd name="connsiteY0" fmla="*/ 1188345 h 1188345"/>
                <a:gd name="connsiteX1" fmla="*/ 236191 w 1218766"/>
                <a:gd name="connsiteY1" fmla="*/ 360207 h 1188345"/>
                <a:gd name="connsiteX2" fmla="*/ 553916 w 1218766"/>
                <a:gd name="connsiteY2" fmla="*/ 26931 h 1188345"/>
                <a:gd name="connsiteX3" fmla="*/ 1201165 w 1218766"/>
                <a:gd name="connsiteY3" fmla="*/ 0 h 1188345"/>
                <a:gd name="connsiteX4" fmla="*/ 1218448 w 1218766"/>
                <a:gd name="connsiteY4" fmla="*/ 1188069 h 1188345"/>
                <a:gd name="connsiteX5" fmla="*/ 0 w 1218766"/>
                <a:gd name="connsiteY5" fmla="*/ 1188345 h 11883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218766" h="1188345">
                  <a:moveTo>
                    <a:pt x="0" y="1188345"/>
                  </a:moveTo>
                  <a:lnTo>
                    <a:pt x="236191" y="360207"/>
                  </a:lnTo>
                  <a:lnTo>
                    <a:pt x="553916" y="26931"/>
                  </a:lnTo>
                  <a:lnTo>
                    <a:pt x="1201165" y="0"/>
                  </a:lnTo>
                  <a:cubicBezTo>
                    <a:pt x="1197833" y="380907"/>
                    <a:pt x="1221780" y="807162"/>
                    <a:pt x="1218448" y="1188069"/>
                  </a:cubicBezTo>
                  <a:lnTo>
                    <a:pt x="0" y="1188345"/>
                  </a:lnTo>
                  <a:close/>
                </a:path>
              </a:pathLst>
            </a:cu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Oval 124">
              <a:extLst>
                <a:ext uri="{FF2B5EF4-FFF2-40B4-BE49-F238E27FC236}">
                  <a16:creationId xmlns:a16="http://schemas.microsoft.com/office/drawing/2014/main" id="{88A2F2D9-66BE-F747-933D-39192BF451FB}"/>
                </a:ext>
              </a:extLst>
            </p:cNvPr>
            <p:cNvSpPr/>
            <p:nvPr/>
          </p:nvSpPr>
          <p:spPr>
            <a:xfrm>
              <a:off x="5752107" y="9071580"/>
              <a:ext cx="833620" cy="721249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Oval 125">
              <a:extLst>
                <a:ext uri="{FF2B5EF4-FFF2-40B4-BE49-F238E27FC236}">
                  <a16:creationId xmlns:a16="http://schemas.microsoft.com/office/drawing/2014/main" id="{2C855B46-0154-A062-1174-F337CC464C77}"/>
                </a:ext>
              </a:extLst>
            </p:cNvPr>
            <p:cNvSpPr/>
            <p:nvPr/>
          </p:nvSpPr>
          <p:spPr>
            <a:xfrm>
              <a:off x="5796543" y="8269325"/>
              <a:ext cx="789183" cy="570716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Oval 126">
              <a:extLst>
                <a:ext uri="{FF2B5EF4-FFF2-40B4-BE49-F238E27FC236}">
                  <a16:creationId xmlns:a16="http://schemas.microsoft.com/office/drawing/2014/main" id="{3A443441-FB83-7DE2-2FDA-22604893576A}"/>
                </a:ext>
              </a:extLst>
            </p:cNvPr>
            <p:cNvSpPr/>
            <p:nvPr/>
          </p:nvSpPr>
          <p:spPr>
            <a:xfrm>
              <a:off x="7999954" y="9071580"/>
              <a:ext cx="833620" cy="721249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Oval 127">
              <a:extLst>
                <a:ext uri="{FF2B5EF4-FFF2-40B4-BE49-F238E27FC236}">
                  <a16:creationId xmlns:a16="http://schemas.microsoft.com/office/drawing/2014/main" id="{D889224F-8686-4FBB-EC26-E06A0E28FD4B}"/>
                </a:ext>
              </a:extLst>
            </p:cNvPr>
            <p:cNvSpPr/>
            <p:nvPr/>
          </p:nvSpPr>
          <p:spPr>
            <a:xfrm>
              <a:off x="8044391" y="8269325"/>
              <a:ext cx="789183" cy="570716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89E2EFBF-2C6E-0FEB-2F5B-B97EC23115DD}"/>
              </a:ext>
            </a:extLst>
          </p:cNvPr>
          <p:cNvSpPr txBox="1"/>
          <p:nvPr/>
        </p:nvSpPr>
        <p:spPr>
          <a:xfrm>
            <a:off x="27025" y="10511099"/>
            <a:ext cx="935990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Minus One (FMO) controls for flow cytometry of a)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ious markers in murine C57Bl/6 aorta (related to Fig. 1 E-F);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ternate gating strategy for EVPs in murine C57Bl/6 aorta (related to Fig. 1i);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d)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gfr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CreMer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/ROSA-EYFP lineage traced aorta (C, related to Fig. 4E) and full-skin excisional wounds (D, related to Fig. 5D)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99D3915-D8D2-70B2-6820-FAFF0E92B886}"/>
              </a:ext>
            </a:extLst>
          </p:cNvPr>
          <p:cNvSpPr txBox="1"/>
          <p:nvPr/>
        </p:nvSpPr>
        <p:spPr>
          <a:xfrm>
            <a:off x="1090583" y="2900942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MO</a:t>
            </a:r>
          </a:p>
        </p:txBody>
      </p:sp>
    </p:spTree>
    <p:extLst>
      <p:ext uri="{BB962C8B-B14F-4D97-AF65-F5344CB8AC3E}">
        <p14:creationId xmlns:p14="http://schemas.microsoft.com/office/powerpoint/2010/main" val="13180006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>
            <a:extLst>
              <a:ext uri="{FF2B5EF4-FFF2-40B4-BE49-F238E27FC236}">
                <a16:creationId xmlns:a16="http://schemas.microsoft.com/office/drawing/2014/main" id="{A12CB953-5C1E-A058-4121-976E4397E905}"/>
              </a:ext>
            </a:extLst>
          </p:cNvPr>
          <p:cNvSpPr txBox="1"/>
          <p:nvPr/>
        </p:nvSpPr>
        <p:spPr>
          <a:xfrm>
            <a:off x="68343" y="9818294"/>
            <a:ext cx="935989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Additional single cell RNA-sequencing analyses and flow cytometric FMOs for human datasets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ing across three samples of normal human aorta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gleR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biased 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eling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d)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s of top DE genes in EVP (C) and M cell (D) clusters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)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ING pathway analysis of top DE genes in EVP clusters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)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MO controls for human term placenta FACS-sorting. </a:t>
            </a:r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) 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olin plots showing expression of (</a:t>
            </a:r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D34 (ii) PROCR and (iii) PDGFRA in normal human aorta (n=3).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2022668C-F501-D39B-2D8C-A0324ACC0A6A}"/>
              </a:ext>
            </a:extLst>
          </p:cNvPr>
          <p:cNvGrpSpPr/>
          <p:nvPr/>
        </p:nvGrpSpPr>
        <p:grpSpPr>
          <a:xfrm>
            <a:off x="-28533" y="-8813"/>
            <a:ext cx="9388434" cy="9749951"/>
            <a:chOff x="-28533" y="-8813"/>
            <a:chExt cx="9388434" cy="974995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EB927AC-053E-B747-A06D-2D8C368327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9540" t="8309" b="15411"/>
            <a:stretch/>
          </p:blipFill>
          <p:spPr>
            <a:xfrm>
              <a:off x="265284" y="9044"/>
              <a:ext cx="4348167" cy="2905673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81148F3-351F-5B26-5B36-8527753BB26E}"/>
                </a:ext>
              </a:extLst>
            </p:cNvPr>
            <p:cNvSpPr txBox="1"/>
            <p:nvPr/>
          </p:nvSpPr>
          <p:spPr>
            <a:xfrm>
              <a:off x="29753" y="16005"/>
              <a:ext cx="407257" cy="3668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781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4707986-5C8E-10E9-A7FE-6088759550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016" t="9139" r="1029" b="8066"/>
            <a:stretch/>
          </p:blipFill>
          <p:spPr>
            <a:xfrm>
              <a:off x="4817079" y="27774"/>
              <a:ext cx="4216358" cy="2905673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E517AFB-34E5-3F30-F998-F4A3AAC54C26}"/>
                </a:ext>
              </a:extLst>
            </p:cNvPr>
            <p:cNvSpPr txBox="1"/>
            <p:nvPr/>
          </p:nvSpPr>
          <p:spPr>
            <a:xfrm>
              <a:off x="4436346" y="-8813"/>
              <a:ext cx="407257" cy="3668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781" b="1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pic>
          <p:nvPicPr>
            <p:cNvPr id="8" name="Picture 7" descr="Chart, scatter chart&#10;&#10;Description automatically generated">
              <a:extLst>
                <a:ext uri="{FF2B5EF4-FFF2-40B4-BE49-F238E27FC236}">
                  <a16:creationId xmlns:a16="http://schemas.microsoft.com/office/drawing/2014/main" id="{7AA742BB-60DB-0FCE-2CA8-95BB47E714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" r="-1158"/>
            <a:stretch/>
          </p:blipFill>
          <p:spPr>
            <a:xfrm>
              <a:off x="123813" y="3052520"/>
              <a:ext cx="4525734" cy="2613957"/>
            </a:xfrm>
            <a:prstGeom prst="rect">
              <a:avLst/>
            </a:prstGeom>
          </p:spPr>
        </p:pic>
        <p:pic>
          <p:nvPicPr>
            <p:cNvPr id="11" name="Picture 10" descr="Chart, line chart, scatter chart&#10;&#10;Description automatically generated">
              <a:extLst>
                <a:ext uri="{FF2B5EF4-FFF2-40B4-BE49-F238E27FC236}">
                  <a16:creationId xmlns:a16="http://schemas.microsoft.com/office/drawing/2014/main" id="{26CF75E4-EF98-D9F8-E4BA-6E550F4215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-348"/>
            <a:stretch/>
          </p:blipFill>
          <p:spPr>
            <a:xfrm>
              <a:off x="4613451" y="3059215"/>
              <a:ext cx="4525735" cy="2529168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51CC226-C572-A0FA-AA94-8E0ED0AA9917}"/>
                </a:ext>
              </a:extLst>
            </p:cNvPr>
            <p:cNvSpPr txBox="1"/>
            <p:nvPr/>
          </p:nvSpPr>
          <p:spPr>
            <a:xfrm>
              <a:off x="-28533" y="2932574"/>
              <a:ext cx="407257" cy="36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781" b="1" dirty="0">
                  <a:latin typeface="Arial" panose="020B0604020202020204" pitchFamily="34" charset="0"/>
                  <a:cs typeface="Arial" panose="020B0604020202020204" pitchFamily="34" charset="0"/>
                </a:rPr>
                <a:t>c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58E3233-EE54-238C-AD2D-ED64DEED2DBD}"/>
                </a:ext>
              </a:extLst>
            </p:cNvPr>
            <p:cNvSpPr txBox="1"/>
            <p:nvPr/>
          </p:nvSpPr>
          <p:spPr>
            <a:xfrm>
              <a:off x="4409822" y="2945658"/>
              <a:ext cx="407257" cy="3668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781" b="1" dirty="0">
                  <a:latin typeface="Arial" panose="020B0604020202020204" pitchFamily="34" charset="0"/>
                  <a:cs typeface="Arial" panose="020B0604020202020204" pitchFamily="34" charset="0"/>
                </a:rPr>
                <a:t>d)</a:t>
              </a:r>
            </a:p>
          </p:txBody>
        </p:sp>
        <p:pic>
          <p:nvPicPr>
            <p:cNvPr id="16" name="Picture 15" descr="A picture containing indoor&#10;&#10;Description automatically generated">
              <a:extLst>
                <a:ext uri="{FF2B5EF4-FFF2-40B4-BE49-F238E27FC236}">
                  <a16:creationId xmlns:a16="http://schemas.microsoft.com/office/drawing/2014/main" id="{4911ACC9-6DAB-460F-90A8-E57E5CFC9BA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5095" y="5684747"/>
              <a:ext cx="3321335" cy="2269876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1B0FC8B-CDC4-B736-5E97-9FE779DE7203}"/>
                </a:ext>
              </a:extLst>
            </p:cNvPr>
            <p:cNvSpPr txBox="1"/>
            <p:nvPr/>
          </p:nvSpPr>
          <p:spPr>
            <a:xfrm>
              <a:off x="68343" y="5682771"/>
              <a:ext cx="407257" cy="3668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781" b="1" dirty="0">
                  <a:latin typeface="Arial" panose="020B0604020202020204" pitchFamily="34" charset="0"/>
                  <a:cs typeface="Arial" panose="020B0604020202020204" pitchFamily="34" charset="0"/>
                </a:rPr>
                <a:t>e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02A2118-B346-B42C-A904-EFD8B83D4375}"/>
                </a:ext>
              </a:extLst>
            </p:cNvPr>
            <p:cNvSpPr txBox="1"/>
            <p:nvPr/>
          </p:nvSpPr>
          <p:spPr>
            <a:xfrm>
              <a:off x="6975303" y="7305141"/>
              <a:ext cx="1012874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00" dirty="0">
                  <a:latin typeface="Arial" panose="020B0604020202020204" pitchFamily="34" charset="0"/>
                  <a:cs typeface="Arial" panose="020B0604020202020204" pitchFamily="34" charset="0"/>
                </a:rPr>
                <a:t>PROCR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363C756-FD49-E36A-6C7E-3DBE98A22E84}"/>
                </a:ext>
              </a:extLst>
            </p:cNvPr>
            <p:cNvSpPr txBox="1"/>
            <p:nvPr/>
          </p:nvSpPr>
          <p:spPr>
            <a:xfrm>
              <a:off x="4123064" y="7306793"/>
              <a:ext cx="765232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CD1B434-02AE-3283-6B3F-1FA3A6B775C4}"/>
                </a:ext>
              </a:extLst>
            </p:cNvPr>
            <p:cNvSpPr txBox="1"/>
            <p:nvPr/>
          </p:nvSpPr>
          <p:spPr>
            <a:xfrm>
              <a:off x="5501250" y="7307312"/>
              <a:ext cx="765232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CAFA4A9-5564-AA9A-E0ED-36B574309FFB}"/>
                </a:ext>
              </a:extLst>
            </p:cNvPr>
            <p:cNvSpPr txBox="1"/>
            <p:nvPr/>
          </p:nvSpPr>
          <p:spPr>
            <a:xfrm>
              <a:off x="8432480" y="7321399"/>
              <a:ext cx="767714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00" dirty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37407A40-D85E-B8DC-59E9-CCE710E8429D}"/>
                </a:ext>
              </a:extLst>
            </p:cNvPr>
            <p:cNvGrpSpPr/>
            <p:nvPr/>
          </p:nvGrpSpPr>
          <p:grpSpPr>
            <a:xfrm>
              <a:off x="3457482" y="5718300"/>
              <a:ext cx="5891225" cy="1663574"/>
              <a:chOff x="109878" y="8487292"/>
              <a:chExt cx="8856157" cy="2173173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230E079B-D217-D2BA-168D-03B25D1694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54884" b="10220"/>
              <a:stretch/>
            </p:blipFill>
            <p:spPr>
              <a:xfrm>
                <a:off x="6958916" y="8725959"/>
                <a:ext cx="2007119" cy="1934506"/>
              </a:xfrm>
              <a:prstGeom prst="rect">
                <a:avLst/>
              </a:prstGeom>
            </p:spPr>
          </p:pic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C8CBB721-D0BB-0BB1-D0BB-F318422939C4}"/>
                  </a:ext>
                </a:extLst>
              </p:cNvPr>
              <p:cNvGrpSpPr/>
              <p:nvPr/>
            </p:nvGrpSpPr>
            <p:grpSpPr>
              <a:xfrm>
                <a:off x="495628" y="8700494"/>
                <a:ext cx="1864914" cy="1934506"/>
                <a:chOff x="406429" y="9900163"/>
                <a:chExt cx="1858140" cy="1927479"/>
              </a:xfrm>
            </p:grpSpPr>
            <p:pic>
              <p:nvPicPr>
                <p:cNvPr id="21" name="Picture 20">
                  <a:extLst>
                    <a:ext uri="{FF2B5EF4-FFF2-40B4-BE49-F238E27FC236}">
                      <a16:creationId xmlns:a16="http://schemas.microsoft.com/office/drawing/2014/main" id="{40CFCD24-6EF1-88C9-E464-9AE603092FF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7225" r="49499" b="9600"/>
                <a:stretch/>
              </p:blipFill>
              <p:spPr>
                <a:xfrm>
                  <a:off x="406429" y="9900163"/>
                  <a:ext cx="1843253" cy="1927479"/>
                </a:xfrm>
                <a:prstGeom prst="rect">
                  <a:avLst/>
                </a:prstGeom>
              </p:spPr>
            </p:pic>
            <p:cxnSp>
              <p:nvCxnSpPr>
                <p:cNvPr id="24" name="Straight Connector 23">
                  <a:extLst>
                    <a:ext uri="{FF2B5EF4-FFF2-40B4-BE49-F238E27FC236}">
                      <a16:creationId xmlns:a16="http://schemas.microsoft.com/office/drawing/2014/main" id="{18A50FC3-3E13-0248-9D8E-AEFD03E22415}"/>
                    </a:ext>
                  </a:extLst>
                </p:cNvPr>
                <p:cNvCxnSpPr/>
                <p:nvPr/>
              </p:nvCxnSpPr>
              <p:spPr>
                <a:xfrm>
                  <a:off x="2264569" y="9965531"/>
                  <a:ext cx="0" cy="166092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A97AB89D-DD54-6EE8-7039-35DF3EA67A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5557" r="49327" b="10220"/>
              <a:stretch/>
            </p:blipFill>
            <p:spPr>
              <a:xfrm>
                <a:off x="4754735" y="8725959"/>
                <a:ext cx="2007119" cy="1934506"/>
              </a:xfrm>
              <a:prstGeom prst="rect">
                <a:avLst/>
              </a:prstGeom>
            </p:spPr>
          </p:pic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4CF601A6-25DF-8377-460A-6DBA1DDDA64E}"/>
                  </a:ext>
                </a:extLst>
              </p:cNvPr>
              <p:cNvSpPr txBox="1"/>
              <p:nvPr/>
            </p:nvSpPr>
            <p:spPr>
              <a:xfrm>
                <a:off x="109878" y="8487292"/>
                <a:ext cx="612220" cy="4786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78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)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372B9B65-403A-38C4-CE5A-F9BB7B765B0F}"/>
                  </a:ext>
                </a:extLst>
              </p:cNvPr>
              <p:cNvSpPr txBox="1"/>
              <p:nvPr/>
            </p:nvSpPr>
            <p:spPr>
              <a:xfrm rot="16200000">
                <a:off x="-130191" y="9293777"/>
                <a:ext cx="957581" cy="4395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E3698FD-0C5F-80DA-4DBB-5FE1CA30BBA0}"/>
                  </a:ext>
                </a:extLst>
              </p:cNvPr>
              <p:cNvSpPr txBox="1"/>
              <p:nvPr/>
            </p:nvSpPr>
            <p:spPr>
              <a:xfrm rot="16200000">
                <a:off x="4229062" y="9268305"/>
                <a:ext cx="974658" cy="4395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A5343674-1AC1-B629-0139-0821E5D7A377}"/>
                  </a:ext>
                </a:extLst>
              </p:cNvPr>
              <p:cNvSpPr txBox="1"/>
              <p:nvPr/>
            </p:nvSpPr>
            <p:spPr>
              <a:xfrm rot="16200000">
                <a:off x="6410344" y="9320005"/>
                <a:ext cx="1005862" cy="4395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B66A507B-28F6-30AC-2902-9D7865CDCD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55216" b="9600"/>
              <a:stretch/>
            </p:blipFill>
            <p:spPr>
              <a:xfrm>
                <a:off x="2681327" y="8701786"/>
                <a:ext cx="1914482" cy="1934506"/>
              </a:xfrm>
              <a:prstGeom prst="rect">
                <a:avLst/>
              </a:prstGeom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17485F89-F771-250A-A885-4FCE6F23A2A8}"/>
                  </a:ext>
                </a:extLst>
              </p:cNvPr>
              <p:cNvSpPr txBox="1"/>
              <p:nvPr/>
            </p:nvSpPr>
            <p:spPr>
              <a:xfrm rot="16200000">
                <a:off x="2130225" y="9242489"/>
                <a:ext cx="927604" cy="4395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C8B71D2A-4C69-AA05-0807-E158A3D5E393}"/>
                  </a:ext>
                </a:extLst>
              </p:cNvPr>
              <p:cNvSpPr/>
              <p:nvPr/>
            </p:nvSpPr>
            <p:spPr>
              <a:xfrm>
                <a:off x="875958" y="8996738"/>
                <a:ext cx="622042" cy="45642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1806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AF206324-2070-EDDF-E98A-0A88D8B4050C}"/>
                  </a:ext>
                </a:extLst>
              </p:cNvPr>
              <p:cNvSpPr/>
              <p:nvPr/>
            </p:nvSpPr>
            <p:spPr>
              <a:xfrm>
                <a:off x="3074692" y="8970771"/>
                <a:ext cx="622042" cy="45642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1806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Freeform: Shape 47">
                <a:extLst>
                  <a:ext uri="{FF2B5EF4-FFF2-40B4-BE49-F238E27FC236}">
                    <a16:creationId xmlns:a16="http://schemas.microsoft.com/office/drawing/2014/main" id="{F3A585EF-3222-DD1C-E950-8B36B7C8D7A4}"/>
                  </a:ext>
                </a:extLst>
              </p:cNvPr>
              <p:cNvSpPr/>
              <p:nvPr/>
            </p:nvSpPr>
            <p:spPr>
              <a:xfrm>
                <a:off x="5581580" y="8795603"/>
                <a:ext cx="1134632" cy="1661818"/>
              </a:xfrm>
              <a:custGeom>
                <a:avLst/>
                <a:gdLst>
                  <a:gd name="connsiteX0" fmla="*/ 0 w 1000125"/>
                  <a:gd name="connsiteY0" fmla="*/ 1481138 h 1490663"/>
                  <a:gd name="connsiteX1" fmla="*/ 195263 w 1000125"/>
                  <a:gd name="connsiteY1" fmla="*/ 1257300 h 1490663"/>
                  <a:gd name="connsiteX2" fmla="*/ 180975 w 1000125"/>
                  <a:gd name="connsiteY2" fmla="*/ 0 h 1490663"/>
                  <a:gd name="connsiteX3" fmla="*/ 1000125 w 1000125"/>
                  <a:gd name="connsiteY3" fmla="*/ 9525 h 1490663"/>
                  <a:gd name="connsiteX4" fmla="*/ 995363 w 1000125"/>
                  <a:gd name="connsiteY4" fmla="*/ 1490663 h 1490663"/>
                  <a:gd name="connsiteX5" fmla="*/ 0 w 1000125"/>
                  <a:gd name="connsiteY5" fmla="*/ 1481138 h 1490663"/>
                  <a:gd name="connsiteX0" fmla="*/ 0 w 1000125"/>
                  <a:gd name="connsiteY0" fmla="*/ 1471613 h 1481138"/>
                  <a:gd name="connsiteX1" fmla="*/ 195263 w 1000125"/>
                  <a:gd name="connsiteY1" fmla="*/ 1247775 h 1481138"/>
                  <a:gd name="connsiteX2" fmla="*/ 180975 w 1000125"/>
                  <a:gd name="connsiteY2" fmla="*/ 4762 h 1481138"/>
                  <a:gd name="connsiteX3" fmla="*/ 1000125 w 1000125"/>
                  <a:gd name="connsiteY3" fmla="*/ 0 h 1481138"/>
                  <a:gd name="connsiteX4" fmla="*/ 995363 w 1000125"/>
                  <a:gd name="connsiteY4" fmla="*/ 1481138 h 1481138"/>
                  <a:gd name="connsiteX5" fmla="*/ 0 w 1000125"/>
                  <a:gd name="connsiteY5" fmla="*/ 1471613 h 1481138"/>
                  <a:gd name="connsiteX0" fmla="*/ 0 w 995808"/>
                  <a:gd name="connsiteY0" fmla="*/ 1466851 h 1476376"/>
                  <a:gd name="connsiteX1" fmla="*/ 195263 w 995808"/>
                  <a:gd name="connsiteY1" fmla="*/ 1243013 h 1476376"/>
                  <a:gd name="connsiteX2" fmla="*/ 180975 w 995808"/>
                  <a:gd name="connsiteY2" fmla="*/ 0 h 1476376"/>
                  <a:gd name="connsiteX3" fmla="*/ 995253 w 995808"/>
                  <a:gd name="connsiteY3" fmla="*/ 4763 h 1476376"/>
                  <a:gd name="connsiteX4" fmla="*/ 995363 w 995808"/>
                  <a:gd name="connsiteY4" fmla="*/ 1476376 h 1476376"/>
                  <a:gd name="connsiteX5" fmla="*/ 0 w 995808"/>
                  <a:gd name="connsiteY5" fmla="*/ 1466851 h 1476376"/>
                  <a:gd name="connsiteX0" fmla="*/ 0 w 995808"/>
                  <a:gd name="connsiteY0" fmla="*/ 1466851 h 1476376"/>
                  <a:gd name="connsiteX1" fmla="*/ 185517 w 995808"/>
                  <a:gd name="connsiteY1" fmla="*/ 1243013 h 1476376"/>
                  <a:gd name="connsiteX2" fmla="*/ 180975 w 995808"/>
                  <a:gd name="connsiteY2" fmla="*/ 0 h 1476376"/>
                  <a:gd name="connsiteX3" fmla="*/ 995253 w 995808"/>
                  <a:gd name="connsiteY3" fmla="*/ 4763 h 1476376"/>
                  <a:gd name="connsiteX4" fmla="*/ 995363 w 995808"/>
                  <a:gd name="connsiteY4" fmla="*/ 1476376 h 1476376"/>
                  <a:gd name="connsiteX5" fmla="*/ 0 w 995808"/>
                  <a:gd name="connsiteY5" fmla="*/ 1466851 h 1476376"/>
                  <a:gd name="connsiteX0" fmla="*/ 0 w 995808"/>
                  <a:gd name="connsiteY0" fmla="*/ 1466851 h 1476376"/>
                  <a:gd name="connsiteX1" fmla="*/ 190390 w 995808"/>
                  <a:gd name="connsiteY1" fmla="*/ 1243013 h 1476376"/>
                  <a:gd name="connsiteX2" fmla="*/ 180975 w 995808"/>
                  <a:gd name="connsiteY2" fmla="*/ 0 h 1476376"/>
                  <a:gd name="connsiteX3" fmla="*/ 995253 w 995808"/>
                  <a:gd name="connsiteY3" fmla="*/ 4763 h 1476376"/>
                  <a:gd name="connsiteX4" fmla="*/ 995363 w 995808"/>
                  <a:gd name="connsiteY4" fmla="*/ 1476376 h 1476376"/>
                  <a:gd name="connsiteX5" fmla="*/ 0 w 995808"/>
                  <a:gd name="connsiteY5" fmla="*/ 1466851 h 1476376"/>
                  <a:gd name="connsiteX0" fmla="*/ 0 w 990935"/>
                  <a:gd name="connsiteY0" fmla="*/ 1471614 h 1476376"/>
                  <a:gd name="connsiteX1" fmla="*/ 185517 w 990935"/>
                  <a:gd name="connsiteY1" fmla="*/ 1243013 h 1476376"/>
                  <a:gd name="connsiteX2" fmla="*/ 176102 w 990935"/>
                  <a:gd name="connsiteY2" fmla="*/ 0 h 1476376"/>
                  <a:gd name="connsiteX3" fmla="*/ 990380 w 990935"/>
                  <a:gd name="connsiteY3" fmla="*/ 4763 h 1476376"/>
                  <a:gd name="connsiteX4" fmla="*/ 990490 w 990935"/>
                  <a:gd name="connsiteY4" fmla="*/ 1476376 h 1476376"/>
                  <a:gd name="connsiteX5" fmla="*/ 0 w 990935"/>
                  <a:gd name="connsiteY5" fmla="*/ 1471614 h 1476376"/>
                  <a:gd name="connsiteX0" fmla="*/ 0 w 990935"/>
                  <a:gd name="connsiteY0" fmla="*/ 1471614 h 1476376"/>
                  <a:gd name="connsiteX1" fmla="*/ 185517 w 990935"/>
                  <a:gd name="connsiteY1" fmla="*/ 1266825 h 1476376"/>
                  <a:gd name="connsiteX2" fmla="*/ 176102 w 990935"/>
                  <a:gd name="connsiteY2" fmla="*/ 0 h 1476376"/>
                  <a:gd name="connsiteX3" fmla="*/ 990380 w 990935"/>
                  <a:gd name="connsiteY3" fmla="*/ 4763 h 1476376"/>
                  <a:gd name="connsiteX4" fmla="*/ 990490 w 990935"/>
                  <a:gd name="connsiteY4" fmla="*/ 1476376 h 1476376"/>
                  <a:gd name="connsiteX5" fmla="*/ 0 w 990935"/>
                  <a:gd name="connsiteY5" fmla="*/ 1471614 h 1476376"/>
                  <a:gd name="connsiteX0" fmla="*/ 0 w 990935"/>
                  <a:gd name="connsiteY0" fmla="*/ 1471614 h 1476376"/>
                  <a:gd name="connsiteX1" fmla="*/ 161153 w 990935"/>
                  <a:gd name="connsiteY1" fmla="*/ 1257300 h 1476376"/>
                  <a:gd name="connsiteX2" fmla="*/ 176102 w 990935"/>
                  <a:gd name="connsiteY2" fmla="*/ 0 h 1476376"/>
                  <a:gd name="connsiteX3" fmla="*/ 990380 w 990935"/>
                  <a:gd name="connsiteY3" fmla="*/ 4763 h 1476376"/>
                  <a:gd name="connsiteX4" fmla="*/ 990490 w 990935"/>
                  <a:gd name="connsiteY4" fmla="*/ 1476376 h 1476376"/>
                  <a:gd name="connsiteX5" fmla="*/ 0 w 990935"/>
                  <a:gd name="connsiteY5" fmla="*/ 1471614 h 1476376"/>
                  <a:gd name="connsiteX0" fmla="*/ 0 w 990935"/>
                  <a:gd name="connsiteY0" fmla="*/ 1471614 h 1476376"/>
                  <a:gd name="connsiteX1" fmla="*/ 170899 w 990935"/>
                  <a:gd name="connsiteY1" fmla="*/ 1266825 h 1476376"/>
                  <a:gd name="connsiteX2" fmla="*/ 176102 w 990935"/>
                  <a:gd name="connsiteY2" fmla="*/ 0 h 1476376"/>
                  <a:gd name="connsiteX3" fmla="*/ 990380 w 990935"/>
                  <a:gd name="connsiteY3" fmla="*/ 4763 h 1476376"/>
                  <a:gd name="connsiteX4" fmla="*/ 990490 w 990935"/>
                  <a:gd name="connsiteY4" fmla="*/ 1476376 h 1476376"/>
                  <a:gd name="connsiteX5" fmla="*/ 0 w 990935"/>
                  <a:gd name="connsiteY5" fmla="*/ 1471614 h 1476376"/>
                  <a:gd name="connsiteX0" fmla="*/ 0 w 990935"/>
                  <a:gd name="connsiteY0" fmla="*/ 1471614 h 1476376"/>
                  <a:gd name="connsiteX1" fmla="*/ 178014 w 990935"/>
                  <a:gd name="connsiteY1" fmla="*/ 1266825 h 1476376"/>
                  <a:gd name="connsiteX2" fmla="*/ 176102 w 990935"/>
                  <a:gd name="connsiteY2" fmla="*/ 0 h 1476376"/>
                  <a:gd name="connsiteX3" fmla="*/ 990380 w 990935"/>
                  <a:gd name="connsiteY3" fmla="*/ 4763 h 1476376"/>
                  <a:gd name="connsiteX4" fmla="*/ 990490 w 990935"/>
                  <a:gd name="connsiteY4" fmla="*/ 1476376 h 1476376"/>
                  <a:gd name="connsiteX5" fmla="*/ 0 w 990935"/>
                  <a:gd name="connsiteY5" fmla="*/ 1471614 h 14763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990935" h="1476376">
                    <a:moveTo>
                      <a:pt x="0" y="1471614"/>
                    </a:moveTo>
                    <a:lnTo>
                      <a:pt x="178014" y="1266825"/>
                    </a:lnTo>
                    <a:cubicBezTo>
                      <a:pt x="174876" y="852487"/>
                      <a:pt x="179240" y="414338"/>
                      <a:pt x="176102" y="0"/>
                    </a:cubicBezTo>
                    <a:lnTo>
                      <a:pt x="990380" y="4763"/>
                    </a:lnTo>
                    <a:cubicBezTo>
                      <a:pt x="988793" y="498476"/>
                      <a:pt x="992077" y="982663"/>
                      <a:pt x="990490" y="1476376"/>
                    </a:cubicBezTo>
                    <a:lnTo>
                      <a:pt x="0" y="1471614"/>
                    </a:lnTo>
                    <a:close/>
                  </a:path>
                </a:pathLst>
              </a:cu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1799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CEE71E10-9924-335D-0FD4-DFA88E39A6FA}"/>
                  </a:ext>
                </a:extLst>
              </p:cNvPr>
              <p:cNvGrpSpPr/>
              <p:nvPr/>
            </p:nvGrpSpPr>
            <p:grpSpPr>
              <a:xfrm>
                <a:off x="7248026" y="8808153"/>
                <a:ext cx="1651788" cy="1661401"/>
                <a:chOff x="7118097" y="7793176"/>
                <a:chExt cx="1750795" cy="1727333"/>
              </a:xfrm>
            </p:grpSpPr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66D44C55-DEA8-82D1-38B3-64710C4BE8D4}"/>
                    </a:ext>
                  </a:extLst>
                </p:cNvPr>
                <p:cNvSpPr/>
                <p:nvPr/>
              </p:nvSpPr>
              <p:spPr>
                <a:xfrm>
                  <a:off x="7118097" y="7793177"/>
                  <a:ext cx="1750795" cy="1727332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 sz="1799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E2BB576A-5BC4-6A23-BA4C-58E2E2E3E33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55442" y="7793176"/>
                  <a:ext cx="12745" cy="146444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E28DB450-7484-2F9C-C0FE-ACB32AB4119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170015" y="7793176"/>
                  <a:ext cx="12745" cy="145917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>
                  <a:extLst>
                    <a:ext uri="{FF2B5EF4-FFF2-40B4-BE49-F238E27FC236}">
                      <a16:creationId xmlns:a16="http://schemas.microsoft.com/office/drawing/2014/main" id="{8D2C60C6-43B2-0D40-88C0-B0B88383DA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473820" y="7793178"/>
                  <a:ext cx="12745" cy="14722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Straight Connector 34">
                  <a:extLst>
                    <a:ext uri="{FF2B5EF4-FFF2-40B4-BE49-F238E27FC236}">
                      <a16:creationId xmlns:a16="http://schemas.microsoft.com/office/drawing/2014/main" id="{CA5137D7-B8A9-3A94-18CD-F29D7587E8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775478" y="9257617"/>
                  <a:ext cx="191954" cy="25981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AA8F77D8-0616-EBDB-33AE-8BEB29403B4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994836" y="9251361"/>
                  <a:ext cx="191954" cy="25981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Connector 36">
                  <a:extLst>
                    <a:ext uri="{FF2B5EF4-FFF2-40B4-BE49-F238E27FC236}">
                      <a16:creationId xmlns:a16="http://schemas.microsoft.com/office/drawing/2014/main" id="{5EDCAB9B-4FD3-6840-EB16-05094E1310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329118" y="9260376"/>
                  <a:ext cx="159928" cy="25981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39" name="Picture 38" descr="A diagram of a tree&#10;&#10;Description automatically generated">
              <a:extLst>
                <a:ext uri="{FF2B5EF4-FFF2-40B4-BE49-F238E27FC236}">
                  <a16:creationId xmlns:a16="http://schemas.microsoft.com/office/drawing/2014/main" id="{1ADCC702-BC1F-8E85-4708-8228042D74F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" y="8012138"/>
              <a:ext cx="3073438" cy="1717510"/>
            </a:xfrm>
            <a:prstGeom prst="rect">
              <a:avLst/>
            </a:prstGeom>
          </p:spPr>
        </p:pic>
        <p:pic>
          <p:nvPicPr>
            <p:cNvPr id="40" name="Picture 39" descr="A graph of a number of trees&#10;&#10;Description automatically generated with medium confidence">
              <a:extLst>
                <a:ext uri="{FF2B5EF4-FFF2-40B4-BE49-F238E27FC236}">
                  <a16:creationId xmlns:a16="http://schemas.microsoft.com/office/drawing/2014/main" id="{D8CDAC1A-2738-1233-9ADF-8DFDC60B484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57614" y="8023628"/>
              <a:ext cx="3073438" cy="1717510"/>
            </a:xfrm>
            <a:prstGeom prst="rect">
              <a:avLst/>
            </a:prstGeom>
          </p:spPr>
        </p:pic>
        <p:pic>
          <p:nvPicPr>
            <p:cNvPr id="42" name="Picture 41" descr="A diagram of a tree&#10;&#10;Description automatically generated">
              <a:extLst>
                <a:ext uri="{FF2B5EF4-FFF2-40B4-BE49-F238E27FC236}">
                  <a16:creationId xmlns:a16="http://schemas.microsoft.com/office/drawing/2014/main" id="{86D95402-1DE6-ED8E-8B0A-03D34C3118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6286463" y="8012138"/>
              <a:ext cx="3073438" cy="1717510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F5976AA-6EA9-CA8D-CC83-F57DF5D998DE}"/>
                </a:ext>
              </a:extLst>
            </p:cNvPr>
            <p:cNvSpPr txBox="1"/>
            <p:nvPr/>
          </p:nvSpPr>
          <p:spPr>
            <a:xfrm>
              <a:off x="23831" y="7880474"/>
              <a:ext cx="407257" cy="3663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781" b="1" dirty="0">
                  <a:latin typeface="Arial" panose="020B0604020202020204" pitchFamily="34" charset="0"/>
                  <a:cs typeface="Arial" panose="020B0604020202020204" pitchFamily="34" charset="0"/>
                </a:rPr>
                <a:t>g)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A9B0CEAA-0004-3AD9-5ED0-11215142E190}"/>
                </a:ext>
              </a:extLst>
            </p:cNvPr>
            <p:cNvSpPr txBox="1"/>
            <p:nvPr/>
          </p:nvSpPr>
          <p:spPr>
            <a:xfrm>
              <a:off x="244178" y="7875489"/>
              <a:ext cx="4026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AU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E6203F1-536B-7D65-D2AF-C460C7FCF642}"/>
                </a:ext>
              </a:extLst>
            </p:cNvPr>
            <p:cNvSpPr txBox="1"/>
            <p:nvPr/>
          </p:nvSpPr>
          <p:spPr>
            <a:xfrm>
              <a:off x="3178494" y="7904135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(ii)</a:t>
              </a:r>
              <a:endParaRPr lang="en-AU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072C427D-1A52-6795-B782-D36F6AE383E2}"/>
                </a:ext>
              </a:extLst>
            </p:cNvPr>
            <p:cNvSpPr txBox="1"/>
            <p:nvPr/>
          </p:nvSpPr>
          <p:spPr>
            <a:xfrm>
              <a:off x="6325122" y="7895100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(iii)</a:t>
              </a:r>
              <a:endParaRPr lang="en-AU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80544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</TotalTime>
  <Words>428</Words>
  <Application>Microsoft Office PowerPoint</Application>
  <PresentationFormat>Custom</PresentationFormat>
  <Paragraphs>72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mranpreet Kaur</dc:creator>
  <cp:lastModifiedBy>Abbas Shafiee</cp:lastModifiedBy>
  <cp:revision>7</cp:revision>
  <dcterms:created xsi:type="dcterms:W3CDTF">2024-10-02T01:07:02Z</dcterms:created>
  <dcterms:modified xsi:type="dcterms:W3CDTF">2026-05-14T04:09:28Z</dcterms:modified>
</cp:coreProperties>
</file>